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82" r:id="rId2"/>
    <p:sldId id="281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5909"/>
  </p:normalViewPr>
  <p:slideViewPr>
    <p:cSldViewPr snapToGrid="0" snapToObjects="1">
      <p:cViewPr varScale="1">
        <p:scale>
          <a:sx n="115" d="100"/>
          <a:sy n="115" d="100"/>
        </p:scale>
        <p:origin x="39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443CFF6-7936-3B4A-9725-34895D959AC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19617DA-2782-B64B-8BA6-C531CA9B096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AD9B65-BF4B-344A-874F-A42CC079E7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17AB6-D1D1-DE42-BDCD-112834FEE39E}" type="datetimeFigureOut">
              <a:rPr lang="en-US" smtClean="0"/>
              <a:t>12/1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50475C-97B5-D34F-AD1B-3D06245760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1940F0-8B48-C44A-8A81-DDBBC174C6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4F478-18EA-F447-BBC8-2EB7A3024D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941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46A0C3-BA82-1546-B742-5519C72970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5DD68B0-DD4E-464D-A483-3898294B71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1B021A-4F95-104F-904C-0C43B20F91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17AB6-D1D1-DE42-BDCD-112834FEE39E}" type="datetimeFigureOut">
              <a:rPr lang="en-US" smtClean="0"/>
              <a:t>12/1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05D2D2-F8BD-3443-93A2-EF2C871652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356E54-91C0-B641-8D11-C9B602F946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4F478-18EA-F447-BBC8-2EB7A3024D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6456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30E92B7-0912-D745-8FEF-C5FC1FE77A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6429A8B-844E-904E-B5C0-DF601EEB72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E4A8E20-8591-F945-8436-F965092D58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17AB6-D1D1-DE42-BDCD-112834FEE39E}" type="datetimeFigureOut">
              <a:rPr lang="en-US" smtClean="0"/>
              <a:t>12/1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01DC4C-1C52-4349-A8D1-5C340679EC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F1C354-C5E0-C54E-ABDF-85DA4BAC5C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4F478-18EA-F447-BBC8-2EB7A3024D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134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B7C9F1-C176-514A-AF28-B1E7770F7B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125856-7AD3-C842-AD31-C5E0DACE58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63445A-75DD-B243-9714-757750538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17AB6-D1D1-DE42-BDCD-112834FEE39E}" type="datetimeFigureOut">
              <a:rPr lang="en-US" smtClean="0"/>
              <a:t>12/1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BE2315-198F-9E47-9C72-6308C8118B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597D22-351D-2849-8588-85474BA927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4F478-18EA-F447-BBC8-2EB7A3024D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7259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5407AA-B3E5-F749-B987-08995DD45C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05E7A6-3501-F548-B520-191912F411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67A787-3C79-BE49-9781-6B85BF852D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17AB6-D1D1-DE42-BDCD-112834FEE39E}" type="datetimeFigureOut">
              <a:rPr lang="en-US" smtClean="0"/>
              <a:t>12/1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D5C17C-2289-2D4E-807D-8ADC4EE6FC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89B279-9FD6-4C4C-ACC2-06C5C7A2B1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4F478-18EA-F447-BBC8-2EB7A3024D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7510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636ADB-B6C2-EA43-A326-0AD5F2F270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90B0129-C499-2045-A47A-7CC32C625B8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0F54B7-1DDE-4B4A-AF2E-D0401DC8F2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AED953F-3C2E-3148-B239-C67E4C8402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17AB6-D1D1-DE42-BDCD-112834FEE39E}" type="datetimeFigureOut">
              <a:rPr lang="en-US" smtClean="0"/>
              <a:t>12/1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307DA2-E92A-D843-8D19-DD5E8DE541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C7AEE97-C9EA-FF41-9B49-6265C37CC1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4F478-18EA-F447-BBC8-2EB7A3024D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2470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936AC2-87A2-F94C-9762-89136A751E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A20EDCF-3018-9C42-B03A-709AB19ADD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2E342A0-CC91-6C44-9D78-F34957B7E6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00CFBDC-E53C-894D-A596-AAEF91A4185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5E03A42-D396-024A-98BA-F2B6A74563D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2A82AB6-300A-8E4E-9B3E-4609774422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17AB6-D1D1-DE42-BDCD-112834FEE39E}" type="datetimeFigureOut">
              <a:rPr lang="en-US" smtClean="0"/>
              <a:t>12/12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37B8C6B-154E-E843-B0E6-414DF48584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06673A0-9D7F-094B-8E3A-0374FABF61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4F478-18EA-F447-BBC8-2EB7A3024D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039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6C6965-4D65-0A49-A8A8-EB6F5CAB7F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4238086-E619-E04D-BC8C-DFCE788EE4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17AB6-D1D1-DE42-BDCD-112834FEE39E}" type="datetimeFigureOut">
              <a:rPr lang="en-US" smtClean="0"/>
              <a:t>12/12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E493C3E-A70D-4F41-BC93-A911AB9887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43EBE2D-72AB-D941-8D9E-A2112E77A6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4F478-18EA-F447-BBC8-2EB7A3024D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838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6B5001E-AC35-6A45-BD70-0BDB6B6040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17AB6-D1D1-DE42-BDCD-112834FEE39E}" type="datetimeFigureOut">
              <a:rPr lang="en-US" smtClean="0"/>
              <a:t>12/12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7956EC8-1A64-DA4E-B522-730C9A074D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D61E704-A9D1-A74F-9250-923BDD2942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4F478-18EA-F447-BBC8-2EB7A3024D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58790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6DA23A-351C-904A-8A0B-DB0A58E669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4D5C0C-7B89-9646-9FEE-5D68C1C1818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D28621F-4B98-DF42-BE74-A0B70B46F9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64022C-93AA-584C-9F04-D6A5A848DE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17AB6-D1D1-DE42-BDCD-112834FEE39E}" type="datetimeFigureOut">
              <a:rPr lang="en-US" smtClean="0"/>
              <a:t>12/1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19F9ABA-6A57-834B-BA3B-6870BB9D11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2C437F-DD57-3644-9807-3665B63E97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4F478-18EA-F447-BBC8-2EB7A3024D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33100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9AA730-971C-5D46-97CB-1B021AAEAA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0DCBC78-2F73-E14F-9E48-9A2E6C3E2F1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6A291CC-613E-FC4E-B8A5-6FB293672CE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31C3F8-1E4B-FA4D-841E-FB8D488F07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917AB6-D1D1-DE42-BDCD-112834FEE39E}" type="datetimeFigureOut">
              <a:rPr lang="en-US" smtClean="0"/>
              <a:t>12/12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63E34A-79AA-814E-AA19-D6AE4C4C96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6ACDF8-5279-AB45-BDC7-CA812815C6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64F478-18EA-F447-BBC8-2EB7A3024D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31981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6A7CD38-DF86-6D46-93A3-791145772E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CC855E-B760-594D-9FA5-53CE9AE30F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BDF784-C693-8C4F-9181-2374D2B3402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917AB6-D1D1-DE42-BDCD-112834FEE39E}" type="datetimeFigureOut">
              <a:rPr lang="en-US" smtClean="0"/>
              <a:t>12/12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A366B3-EB0D-E64C-8C99-2123A7404A3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AB7688-FC3A-3E4D-9CAD-197070A5964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64F478-18EA-F447-BBC8-2EB7A3024D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63694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76795BCE-94F7-374C-933C-3717DEABEC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67484" y="155068"/>
            <a:ext cx="4033709" cy="3288207"/>
          </a:xfrm>
          <a:prstGeom prst="rect">
            <a:avLst/>
          </a:prstGeom>
        </p:spPr>
      </p:pic>
      <p:grpSp>
        <p:nvGrpSpPr>
          <p:cNvPr id="21" name="Group 20">
            <a:extLst>
              <a:ext uri="{FF2B5EF4-FFF2-40B4-BE49-F238E27FC236}">
                <a16:creationId xmlns:a16="http://schemas.microsoft.com/office/drawing/2014/main" id="{66DD6328-EDA0-9743-81A9-C636CE0D81CC}"/>
              </a:ext>
            </a:extLst>
          </p:cNvPr>
          <p:cNvGrpSpPr/>
          <p:nvPr/>
        </p:nvGrpSpPr>
        <p:grpSpPr>
          <a:xfrm>
            <a:off x="3649438" y="1581430"/>
            <a:ext cx="2069824" cy="1139742"/>
            <a:chOff x="2834641" y="3204733"/>
            <a:chExt cx="2457616" cy="1416808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AF599F4A-4DFF-B540-897B-53B8CCA8A07B}"/>
                </a:ext>
              </a:extLst>
            </p:cNvPr>
            <p:cNvGrpSpPr/>
            <p:nvPr/>
          </p:nvGrpSpPr>
          <p:grpSpPr>
            <a:xfrm>
              <a:off x="2834641" y="3566160"/>
              <a:ext cx="2457616" cy="1055381"/>
              <a:chOff x="2834641" y="3566160"/>
              <a:chExt cx="2457616" cy="1055381"/>
            </a:xfrm>
          </p:grpSpPr>
          <p:sp>
            <p:nvSpPr>
              <p:cNvPr id="13" name="Freeform 12">
                <a:extLst>
                  <a:ext uri="{FF2B5EF4-FFF2-40B4-BE49-F238E27FC236}">
                    <a16:creationId xmlns:a16="http://schemas.microsoft.com/office/drawing/2014/main" id="{C99AF991-2E90-F046-B118-38E4172B248C}"/>
                  </a:ext>
                </a:extLst>
              </p:cNvPr>
              <p:cNvSpPr/>
              <p:nvPr/>
            </p:nvSpPr>
            <p:spPr>
              <a:xfrm>
                <a:off x="2834641" y="3566160"/>
                <a:ext cx="2312126" cy="518159"/>
              </a:xfrm>
              <a:custGeom>
                <a:avLst/>
                <a:gdLst>
                  <a:gd name="connsiteX0" fmla="*/ 0 w 1998617"/>
                  <a:gd name="connsiteY0" fmla="*/ 117566 h 274320"/>
                  <a:gd name="connsiteX1" fmla="*/ 65314 w 1998617"/>
                  <a:gd name="connsiteY1" fmla="*/ 104503 h 274320"/>
                  <a:gd name="connsiteX2" fmla="*/ 143691 w 1998617"/>
                  <a:gd name="connsiteY2" fmla="*/ 52252 h 274320"/>
                  <a:gd name="connsiteX3" fmla="*/ 222068 w 1998617"/>
                  <a:gd name="connsiteY3" fmla="*/ 26126 h 274320"/>
                  <a:gd name="connsiteX4" fmla="*/ 261257 w 1998617"/>
                  <a:gd name="connsiteY4" fmla="*/ 13063 h 274320"/>
                  <a:gd name="connsiteX5" fmla="*/ 300445 w 1998617"/>
                  <a:gd name="connsiteY5" fmla="*/ 0 h 274320"/>
                  <a:gd name="connsiteX6" fmla="*/ 509451 w 1998617"/>
                  <a:gd name="connsiteY6" fmla="*/ 13063 h 274320"/>
                  <a:gd name="connsiteX7" fmla="*/ 574765 w 1998617"/>
                  <a:gd name="connsiteY7" fmla="*/ 26126 h 274320"/>
                  <a:gd name="connsiteX8" fmla="*/ 653142 w 1998617"/>
                  <a:gd name="connsiteY8" fmla="*/ 39189 h 274320"/>
                  <a:gd name="connsiteX9" fmla="*/ 757645 w 1998617"/>
                  <a:gd name="connsiteY9" fmla="*/ 65315 h 274320"/>
                  <a:gd name="connsiteX10" fmla="*/ 822960 w 1998617"/>
                  <a:gd name="connsiteY10" fmla="*/ 78378 h 274320"/>
                  <a:gd name="connsiteX11" fmla="*/ 875211 w 1998617"/>
                  <a:gd name="connsiteY11" fmla="*/ 91440 h 274320"/>
                  <a:gd name="connsiteX12" fmla="*/ 1254034 w 1998617"/>
                  <a:gd name="connsiteY12" fmla="*/ 117566 h 274320"/>
                  <a:gd name="connsiteX13" fmla="*/ 1515291 w 1998617"/>
                  <a:gd name="connsiteY13" fmla="*/ 143692 h 274320"/>
                  <a:gd name="connsiteX14" fmla="*/ 1776548 w 1998617"/>
                  <a:gd name="connsiteY14" fmla="*/ 169818 h 274320"/>
                  <a:gd name="connsiteX15" fmla="*/ 1854925 w 1998617"/>
                  <a:gd name="connsiteY15" fmla="*/ 195943 h 274320"/>
                  <a:gd name="connsiteX16" fmla="*/ 1894114 w 1998617"/>
                  <a:gd name="connsiteY16" fmla="*/ 209006 h 274320"/>
                  <a:gd name="connsiteX17" fmla="*/ 1933302 w 1998617"/>
                  <a:gd name="connsiteY17" fmla="*/ 235132 h 274320"/>
                  <a:gd name="connsiteX18" fmla="*/ 1972491 w 1998617"/>
                  <a:gd name="connsiteY18" fmla="*/ 248195 h 274320"/>
                  <a:gd name="connsiteX19" fmla="*/ 1998617 w 1998617"/>
                  <a:gd name="connsiteY19" fmla="*/ 274320 h 27432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</a:cxnLst>
                <a:rect l="l" t="t" r="r" b="b"/>
                <a:pathLst>
                  <a:path w="1998617" h="274320">
                    <a:moveTo>
                      <a:pt x="0" y="117566"/>
                    </a:moveTo>
                    <a:cubicBezTo>
                      <a:pt x="21771" y="113212"/>
                      <a:pt x="45102" y="113690"/>
                      <a:pt x="65314" y="104503"/>
                    </a:cubicBezTo>
                    <a:cubicBezTo>
                      <a:pt x="93899" y="91510"/>
                      <a:pt x="113903" y="62181"/>
                      <a:pt x="143691" y="52252"/>
                    </a:cubicBezTo>
                    <a:lnTo>
                      <a:pt x="222068" y="26126"/>
                    </a:lnTo>
                    <a:lnTo>
                      <a:pt x="261257" y="13063"/>
                    </a:lnTo>
                    <a:lnTo>
                      <a:pt x="300445" y="0"/>
                    </a:lnTo>
                    <a:cubicBezTo>
                      <a:pt x="370114" y="4354"/>
                      <a:pt x="439961" y="6445"/>
                      <a:pt x="509451" y="13063"/>
                    </a:cubicBezTo>
                    <a:cubicBezTo>
                      <a:pt x="531553" y="15168"/>
                      <a:pt x="552921" y="22154"/>
                      <a:pt x="574765" y="26126"/>
                    </a:cubicBezTo>
                    <a:cubicBezTo>
                      <a:pt x="600824" y="30864"/>
                      <a:pt x="627244" y="33639"/>
                      <a:pt x="653142" y="39189"/>
                    </a:cubicBezTo>
                    <a:cubicBezTo>
                      <a:pt x="688251" y="46713"/>
                      <a:pt x="722436" y="58273"/>
                      <a:pt x="757645" y="65315"/>
                    </a:cubicBezTo>
                    <a:cubicBezTo>
                      <a:pt x="779417" y="69669"/>
                      <a:pt x="801286" y="73562"/>
                      <a:pt x="822960" y="78378"/>
                    </a:cubicBezTo>
                    <a:cubicBezTo>
                      <a:pt x="840485" y="82272"/>
                      <a:pt x="857467" y="88710"/>
                      <a:pt x="875211" y="91440"/>
                    </a:cubicBezTo>
                    <a:cubicBezTo>
                      <a:pt x="1002504" y="111023"/>
                      <a:pt x="1123526" y="109409"/>
                      <a:pt x="1254034" y="117566"/>
                    </a:cubicBezTo>
                    <a:cubicBezTo>
                      <a:pt x="1536291" y="135207"/>
                      <a:pt x="1298155" y="123012"/>
                      <a:pt x="1515291" y="143692"/>
                    </a:cubicBezTo>
                    <a:cubicBezTo>
                      <a:pt x="1792928" y="170134"/>
                      <a:pt x="1587081" y="142751"/>
                      <a:pt x="1776548" y="169818"/>
                    </a:cubicBezTo>
                    <a:lnTo>
                      <a:pt x="1854925" y="195943"/>
                    </a:lnTo>
                    <a:lnTo>
                      <a:pt x="1894114" y="209006"/>
                    </a:lnTo>
                    <a:cubicBezTo>
                      <a:pt x="1907177" y="217715"/>
                      <a:pt x="1919260" y="228111"/>
                      <a:pt x="1933302" y="235132"/>
                    </a:cubicBezTo>
                    <a:cubicBezTo>
                      <a:pt x="1945618" y="241290"/>
                      <a:pt x="1960684" y="241111"/>
                      <a:pt x="1972491" y="248195"/>
                    </a:cubicBezTo>
                    <a:cubicBezTo>
                      <a:pt x="1983052" y="254531"/>
                      <a:pt x="1989908" y="265612"/>
                      <a:pt x="1998617" y="274320"/>
                    </a:cubicBezTo>
                  </a:path>
                </a:pathLst>
              </a:cu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4" name="Freeform 13">
                <a:extLst>
                  <a:ext uri="{FF2B5EF4-FFF2-40B4-BE49-F238E27FC236}">
                    <a16:creationId xmlns:a16="http://schemas.microsoft.com/office/drawing/2014/main" id="{418A657C-8BF6-694D-B403-D5757B06E470}"/>
                  </a:ext>
                </a:extLst>
              </p:cNvPr>
              <p:cNvSpPr/>
              <p:nvPr/>
            </p:nvSpPr>
            <p:spPr>
              <a:xfrm>
                <a:off x="3853543" y="3735976"/>
                <a:ext cx="1438714" cy="885565"/>
              </a:xfrm>
              <a:custGeom>
                <a:avLst/>
                <a:gdLst>
                  <a:gd name="connsiteX0" fmla="*/ 0 w 1645920"/>
                  <a:gd name="connsiteY0" fmla="*/ 0 h 1084218"/>
                  <a:gd name="connsiteX1" fmla="*/ 65314 w 1645920"/>
                  <a:gd name="connsiteY1" fmla="*/ 52252 h 1084218"/>
                  <a:gd name="connsiteX2" fmla="*/ 104503 w 1645920"/>
                  <a:gd name="connsiteY2" fmla="*/ 78378 h 1084218"/>
                  <a:gd name="connsiteX3" fmla="*/ 182880 w 1645920"/>
                  <a:gd name="connsiteY3" fmla="*/ 143692 h 1084218"/>
                  <a:gd name="connsiteX4" fmla="*/ 209006 w 1645920"/>
                  <a:gd name="connsiteY4" fmla="*/ 182880 h 1084218"/>
                  <a:gd name="connsiteX5" fmla="*/ 287383 w 1645920"/>
                  <a:gd name="connsiteY5" fmla="*/ 235132 h 1084218"/>
                  <a:gd name="connsiteX6" fmla="*/ 352697 w 1645920"/>
                  <a:gd name="connsiteY6" fmla="*/ 313509 h 1084218"/>
                  <a:gd name="connsiteX7" fmla="*/ 404949 w 1645920"/>
                  <a:gd name="connsiteY7" fmla="*/ 391886 h 1084218"/>
                  <a:gd name="connsiteX8" fmla="*/ 431074 w 1645920"/>
                  <a:gd name="connsiteY8" fmla="*/ 431075 h 1084218"/>
                  <a:gd name="connsiteX9" fmla="*/ 470263 w 1645920"/>
                  <a:gd name="connsiteY9" fmla="*/ 457200 h 1084218"/>
                  <a:gd name="connsiteX10" fmla="*/ 561703 w 1645920"/>
                  <a:gd name="connsiteY10" fmla="*/ 561703 h 1084218"/>
                  <a:gd name="connsiteX11" fmla="*/ 627017 w 1645920"/>
                  <a:gd name="connsiteY11" fmla="*/ 627018 h 1084218"/>
                  <a:gd name="connsiteX12" fmla="*/ 653143 w 1645920"/>
                  <a:gd name="connsiteY12" fmla="*/ 666206 h 1084218"/>
                  <a:gd name="connsiteX13" fmla="*/ 731520 w 1645920"/>
                  <a:gd name="connsiteY13" fmla="*/ 718458 h 1084218"/>
                  <a:gd name="connsiteX14" fmla="*/ 757646 w 1645920"/>
                  <a:gd name="connsiteY14" fmla="*/ 757646 h 1084218"/>
                  <a:gd name="connsiteX15" fmla="*/ 901337 w 1645920"/>
                  <a:gd name="connsiteY15" fmla="*/ 836023 h 1084218"/>
                  <a:gd name="connsiteX16" fmla="*/ 953589 w 1645920"/>
                  <a:gd name="connsiteY16" fmla="*/ 862149 h 1084218"/>
                  <a:gd name="connsiteX17" fmla="*/ 992777 w 1645920"/>
                  <a:gd name="connsiteY17" fmla="*/ 888275 h 1084218"/>
                  <a:gd name="connsiteX18" fmla="*/ 1123406 w 1645920"/>
                  <a:gd name="connsiteY18" fmla="*/ 914400 h 1084218"/>
                  <a:gd name="connsiteX19" fmla="*/ 1397726 w 1645920"/>
                  <a:gd name="connsiteY19" fmla="*/ 940526 h 1084218"/>
                  <a:gd name="connsiteX20" fmla="*/ 1476103 w 1645920"/>
                  <a:gd name="connsiteY20" fmla="*/ 966652 h 1084218"/>
                  <a:gd name="connsiteX21" fmla="*/ 1515292 w 1645920"/>
                  <a:gd name="connsiteY21" fmla="*/ 979715 h 1084218"/>
                  <a:gd name="connsiteX22" fmla="*/ 1593669 w 1645920"/>
                  <a:gd name="connsiteY22" fmla="*/ 1031966 h 1084218"/>
                  <a:gd name="connsiteX23" fmla="*/ 1645920 w 1645920"/>
                  <a:gd name="connsiteY23" fmla="*/ 1084218 h 1084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</a:cxnLst>
                <a:rect l="l" t="t" r="r" b="b"/>
                <a:pathLst>
                  <a:path w="1645920" h="1084218">
                    <a:moveTo>
                      <a:pt x="0" y="0"/>
                    </a:moveTo>
                    <a:cubicBezTo>
                      <a:pt x="21771" y="17417"/>
                      <a:pt x="43009" y="35523"/>
                      <a:pt x="65314" y="52252"/>
                    </a:cubicBezTo>
                    <a:cubicBezTo>
                      <a:pt x="77874" y="61672"/>
                      <a:pt x="92442" y="68327"/>
                      <a:pt x="104503" y="78378"/>
                    </a:cubicBezTo>
                    <a:cubicBezTo>
                      <a:pt x="205089" y="162198"/>
                      <a:pt x="85578" y="78823"/>
                      <a:pt x="182880" y="143692"/>
                    </a:cubicBezTo>
                    <a:cubicBezTo>
                      <a:pt x="191589" y="156755"/>
                      <a:pt x="197191" y="172542"/>
                      <a:pt x="209006" y="182880"/>
                    </a:cubicBezTo>
                    <a:cubicBezTo>
                      <a:pt x="232636" y="203557"/>
                      <a:pt x="287383" y="235132"/>
                      <a:pt x="287383" y="235132"/>
                    </a:cubicBezTo>
                    <a:cubicBezTo>
                      <a:pt x="380746" y="375173"/>
                      <a:pt x="235348" y="162631"/>
                      <a:pt x="352697" y="313509"/>
                    </a:cubicBezTo>
                    <a:cubicBezTo>
                      <a:pt x="371974" y="338294"/>
                      <a:pt x="387532" y="365760"/>
                      <a:pt x="404949" y="391886"/>
                    </a:cubicBezTo>
                    <a:cubicBezTo>
                      <a:pt x="413658" y="404949"/>
                      <a:pt x="418011" y="422367"/>
                      <a:pt x="431074" y="431075"/>
                    </a:cubicBezTo>
                    <a:lnTo>
                      <a:pt x="470263" y="457200"/>
                    </a:lnTo>
                    <a:cubicBezTo>
                      <a:pt x="531222" y="548641"/>
                      <a:pt x="496388" y="518161"/>
                      <a:pt x="561703" y="561703"/>
                    </a:cubicBezTo>
                    <a:cubicBezTo>
                      <a:pt x="631370" y="666204"/>
                      <a:pt x="539934" y="539935"/>
                      <a:pt x="627017" y="627018"/>
                    </a:cubicBezTo>
                    <a:cubicBezTo>
                      <a:pt x="638118" y="638119"/>
                      <a:pt x="641328" y="655868"/>
                      <a:pt x="653143" y="666206"/>
                    </a:cubicBezTo>
                    <a:cubicBezTo>
                      <a:pt x="676773" y="686883"/>
                      <a:pt x="731520" y="718458"/>
                      <a:pt x="731520" y="718458"/>
                    </a:cubicBezTo>
                    <a:cubicBezTo>
                      <a:pt x="740229" y="731521"/>
                      <a:pt x="746545" y="746545"/>
                      <a:pt x="757646" y="757646"/>
                    </a:cubicBezTo>
                    <a:cubicBezTo>
                      <a:pt x="781513" y="781513"/>
                      <a:pt x="901185" y="835947"/>
                      <a:pt x="901337" y="836023"/>
                    </a:cubicBezTo>
                    <a:cubicBezTo>
                      <a:pt x="918754" y="844732"/>
                      <a:pt x="937386" y="851347"/>
                      <a:pt x="953589" y="862149"/>
                    </a:cubicBezTo>
                    <a:cubicBezTo>
                      <a:pt x="966652" y="870858"/>
                      <a:pt x="977772" y="883658"/>
                      <a:pt x="992777" y="888275"/>
                    </a:cubicBezTo>
                    <a:cubicBezTo>
                      <a:pt x="1035219" y="901334"/>
                      <a:pt x="1079863" y="905692"/>
                      <a:pt x="1123406" y="914400"/>
                    </a:cubicBezTo>
                    <a:cubicBezTo>
                      <a:pt x="1257175" y="941153"/>
                      <a:pt x="1166542" y="926077"/>
                      <a:pt x="1397726" y="940526"/>
                    </a:cubicBezTo>
                    <a:lnTo>
                      <a:pt x="1476103" y="966652"/>
                    </a:lnTo>
                    <a:cubicBezTo>
                      <a:pt x="1489166" y="971006"/>
                      <a:pt x="1503835" y="972077"/>
                      <a:pt x="1515292" y="979715"/>
                    </a:cubicBezTo>
                    <a:lnTo>
                      <a:pt x="1593669" y="1031966"/>
                    </a:lnTo>
                    <a:cubicBezTo>
                      <a:pt x="1640958" y="1063492"/>
                      <a:pt x="1625836" y="1044051"/>
                      <a:pt x="1645920" y="1084218"/>
                    </a:cubicBezTo>
                  </a:path>
                </a:pathLst>
              </a:cu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sp>
          <p:nvSpPr>
            <p:cNvPr id="20" name="Freeform 19">
              <a:extLst>
                <a:ext uri="{FF2B5EF4-FFF2-40B4-BE49-F238E27FC236}">
                  <a16:creationId xmlns:a16="http://schemas.microsoft.com/office/drawing/2014/main" id="{5FF4A24B-4911-5C4D-89F8-D7B1BE1E106F}"/>
                </a:ext>
              </a:extLst>
            </p:cNvPr>
            <p:cNvSpPr/>
            <p:nvPr/>
          </p:nvSpPr>
          <p:spPr>
            <a:xfrm rot="8200495">
              <a:off x="3443321" y="3204733"/>
              <a:ext cx="861518" cy="504350"/>
            </a:xfrm>
            <a:custGeom>
              <a:avLst/>
              <a:gdLst>
                <a:gd name="connsiteX0" fmla="*/ 0 w 1645920"/>
                <a:gd name="connsiteY0" fmla="*/ 0 h 1084218"/>
                <a:gd name="connsiteX1" fmla="*/ 65314 w 1645920"/>
                <a:gd name="connsiteY1" fmla="*/ 52252 h 1084218"/>
                <a:gd name="connsiteX2" fmla="*/ 104503 w 1645920"/>
                <a:gd name="connsiteY2" fmla="*/ 78378 h 1084218"/>
                <a:gd name="connsiteX3" fmla="*/ 182880 w 1645920"/>
                <a:gd name="connsiteY3" fmla="*/ 143692 h 1084218"/>
                <a:gd name="connsiteX4" fmla="*/ 209006 w 1645920"/>
                <a:gd name="connsiteY4" fmla="*/ 182880 h 1084218"/>
                <a:gd name="connsiteX5" fmla="*/ 287383 w 1645920"/>
                <a:gd name="connsiteY5" fmla="*/ 235132 h 1084218"/>
                <a:gd name="connsiteX6" fmla="*/ 352697 w 1645920"/>
                <a:gd name="connsiteY6" fmla="*/ 313509 h 1084218"/>
                <a:gd name="connsiteX7" fmla="*/ 404949 w 1645920"/>
                <a:gd name="connsiteY7" fmla="*/ 391886 h 1084218"/>
                <a:gd name="connsiteX8" fmla="*/ 431074 w 1645920"/>
                <a:gd name="connsiteY8" fmla="*/ 431075 h 1084218"/>
                <a:gd name="connsiteX9" fmla="*/ 470263 w 1645920"/>
                <a:gd name="connsiteY9" fmla="*/ 457200 h 1084218"/>
                <a:gd name="connsiteX10" fmla="*/ 561703 w 1645920"/>
                <a:gd name="connsiteY10" fmla="*/ 561703 h 1084218"/>
                <a:gd name="connsiteX11" fmla="*/ 627017 w 1645920"/>
                <a:gd name="connsiteY11" fmla="*/ 627018 h 1084218"/>
                <a:gd name="connsiteX12" fmla="*/ 653143 w 1645920"/>
                <a:gd name="connsiteY12" fmla="*/ 666206 h 1084218"/>
                <a:gd name="connsiteX13" fmla="*/ 731520 w 1645920"/>
                <a:gd name="connsiteY13" fmla="*/ 718458 h 1084218"/>
                <a:gd name="connsiteX14" fmla="*/ 757646 w 1645920"/>
                <a:gd name="connsiteY14" fmla="*/ 757646 h 1084218"/>
                <a:gd name="connsiteX15" fmla="*/ 901337 w 1645920"/>
                <a:gd name="connsiteY15" fmla="*/ 836023 h 1084218"/>
                <a:gd name="connsiteX16" fmla="*/ 953589 w 1645920"/>
                <a:gd name="connsiteY16" fmla="*/ 862149 h 1084218"/>
                <a:gd name="connsiteX17" fmla="*/ 992777 w 1645920"/>
                <a:gd name="connsiteY17" fmla="*/ 888275 h 1084218"/>
                <a:gd name="connsiteX18" fmla="*/ 1123406 w 1645920"/>
                <a:gd name="connsiteY18" fmla="*/ 914400 h 1084218"/>
                <a:gd name="connsiteX19" fmla="*/ 1397726 w 1645920"/>
                <a:gd name="connsiteY19" fmla="*/ 940526 h 1084218"/>
                <a:gd name="connsiteX20" fmla="*/ 1476103 w 1645920"/>
                <a:gd name="connsiteY20" fmla="*/ 966652 h 1084218"/>
                <a:gd name="connsiteX21" fmla="*/ 1515292 w 1645920"/>
                <a:gd name="connsiteY21" fmla="*/ 979715 h 1084218"/>
                <a:gd name="connsiteX22" fmla="*/ 1593669 w 1645920"/>
                <a:gd name="connsiteY22" fmla="*/ 1031966 h 1084218"/>
                <a:gd name="connsiteX23" fmla="*/ 1645920 w 1645920"/>
                <a:gd name="connsiteY23" fmla="*/ 1084218 h 1084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</a:cxnLst>
              <a:rect l="l" t="t" r="r" b="b"/>
              <a:pathLst>
                <a:path w="1645920" h="1084218">
                  <a:moveTo>
                    <a:pt x="0" y="0"/>
                  </a:moveTo>
                  <a:cubicBezTo>
                    <a:pt x="21771" y="17417"/>
                    <a:pt x="43009" y="35523"/>
                    <a:pt x="65314" y="52252"/>
                  </a:cubicBezTo>
                  <a:cubicBezTo>
                    <a:pt x="77874" y="61672"/>
                    <a:pt x="92442" y="68327"/>
                    <a:pt x="104503" y="78378"/>
                  </a:cubicBezTo>
                  <a:cubicBezTo>
                    <a:pt x="205089" y="162198"/>
                    <a:pt x="85578" y="78823"/>
                    <a:pt x="182880" y="143692"/>
                  </a:cubicBezTo>
                  <a:cubicBezTo>
                    <a:pt x="191589" y="156755"/>
                    <a:pt x="197191" y="172542"/>
                    <a:pt x="209006" y="182880"/>
                  </a:cubicBezTo>
                  <a:cubicBezTo>
                    <a:pt x="232636" y="203557"/>
                    <a:pt x="287383" y="235132"/>
                    <a:pt x="287383" y="235132"/>
                  </a:cubicBezTo>
                  <a:cubicBezTo>
                    <a:pt x="380746" y="375173"/>
                    <a:pt x="235348" y="162631"/>
                    <a:pt x="352697" y="313509"/>
                  </a:cubicBezTo>
                  <a:cubicBezTo>
                    <a:pt x="371974" y="338294"/>
                    <a:pt x="387532" y="365760"/>
                    <a:pt x="404949" y="391886"/>
                  </a:cubicBezTo>
                  <a:cubicBezTo>
                    <a:pt x="413658" y="404949"/>
                    <a:pt x="418011" y="422367"/>
                    <a:pt x="431074" y="431075"/>
                  </a:cubicBezTo>
                  <a:lnTo>
                    <a:pt x="470263" y="457200"/>
                  </a:lnTo>
                  <a:cubicBezTo>
                    <a:pt x="531222" y="548641"/>
                    <a:pt x="496388" y="518161"/>
                    <a:pt x="561703" y="561703"/>
                  </a:cubicBezTo>
                  <a:cubicBezTo>
                    <a:pt x="631370" y="666204"/>
                    <a:pt x="539934" y="539935"/>
                    <a:pt x="627017" y="627018"/>
                  </a:cubicBezTo>
                  <a:cubicBezTo>
                    <a:pt x="638118" y="638119"/>
                    <a:pt x="641328" y="655868"/>
                    <a:pt x="653143" y="666206"/>
                  </a:cubicBezTo>
                  <a:cubicBezTo>
                    <a:pt x="676773" y="686883"/>
                    <a:pt x="731520" y="718458"/>
                    <a:pt x="731520" y="718458"/>
                  </a:cubicBezTo>
                  <a:cubicBezTo>
                    <a:pt x="740229" y="731521"/>
                    <a:pt x="746545" y="746545"/>
                    <a:pt x="757646" y="757646"/>
                  </a:cubicBezTo>
                  <a:cubicBezTo>
                    <a:pt x="781513" y="781513"/>
                    <a:pt x="901185" y="835947"/>
                    <a:pt x="901337" y="836023"/>
                  </a:cubicBezTo>
                  <a:cubicBezTo>
                    <a:pt x="918754" y="844732"/>
                    <a:pt x="937386" y="851347"/>
                    <a:pt x="953589" y="862149"/>
                  </a:cubicBezTo>
                  <a:cubicBezTo>
                    <a:pt x="966652" y="870858"/>
                    <a:pt x="977772" y="883658"/>
                    <a:pt x="992777" y="888275"/>
                  </a:cubicBezTo>
                  <a:cubicBezTo>
                    <a:pt x="1035219" y="901334"/>
                    <a:pt x="1079863" y="905692"/>
                    <a:pt x="1123406" y="914400"/>
                  </a:cubicBezTo>
                  <a:cubicBezTo>
                    <a:pt x="1257175" y="941153"/>
                    <a:pt x="1166542" y="926077"/>
                    <a:pt x="1397726" y="940526"/>
                  </a:cubicBezTo>
                  <a:lnTo>
                    <a:pt x="1476103" y="966652"/>
                  </a:lnTo>
                  <a:cubicBezTo>
                    <a:pt x="1489166" y="971006"/>
                    <a:pt x="1503835" y="972077"/>
                    <a:pt x="1515292" y="979715"/>
                  </a:cubicBezTo>
                  <a:lnTo>
                    <a:pt x="1593669" y="1031966"/>
                  </a:lnTo>
                  <a:cubicBezTo>
                    <a:pt x="1640958" y="1063492"/>
                    <a:pt x="1625836" y="1044051"/>
                    <a:pt x="1645920" y="1084218"/>
                  </a:cubicBezTo>
                </a:path>
              </a:pathLst>
            </a:cu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grpSp>
        <p:nvGrpSpPr>
          <p:cNvPr id="32" name="Group 31">
            <a:extLst>
              <a:ext uri="{FF2B5EF4-FFF2-40B4-BE49-F238E27FC236}">
                <a16:creationId xmlns:a16="http://schemas.microsoft.com/office/drawing/2014/main" id="{0B1710AE-CA9C-0E45-91B0-19625A744E6F}"/>
              </a:ext>
            </a:extLst>
          </p:cNvPr>
          <p:cNvGrpSpPr/>
          <p:nvPr/>
        </p:nvGrpSpPr>
        <p:grpSpPr>
          <a:xfrm>
            <a:off x="3686391" y="1382462"/>
            <a:ext cx="1801067" cy="1432330"/>
            <a:chOff x="3087525" y="2996585"/>
            <a:chExt cx="2138506" cy="1780524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B2E3E01-954F-4D46-9D3E-E55751614387}"/>
                </a:ext>
              </a:extLst>
            </p:cNvPr>
            <p:cNvSpPr txBox="1"/>
            <p:nvPr/>
          </p:nvSpPr>
          <p:spPr>
            <a:xfrm>
              <a:off x="3087525" y="3297572"/>
              <a:ext cx="6801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B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3ECCA9A1-16C5-CE45-BE89-DBC3FE83104E}"/>
                </a:ext>
              </a:extLst>
            </p:cNvPr>
            <p:cNvSpPr txBox="1"/>
            <p:nvPr/>
          </p:nvSpPr>
          <p:spPr>
            <a:xfrm>
              <a:off x="3590904" y="3726469"/>
              <a:ext cx="6801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B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27E22400-4190-D14F-9063-AC05CFF3E944}"/>
                </a:ext>
              </a:extLst>
            </p:cNvPr>
            <p:cNvSpPr txBox="1"/>
            <p:nvPr/>
          </p:nvSpPr>
          <p:spPr>
            <a:xfrm>
              <a:off x="3795840" y="2996585"/>
              <a:ext cx="6801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B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EA4C53CB-FC71-B049-824C-25A732651DBC}"/>
                </a:ext>
              </a:extLst>
            </p:cNvPr>
            <p:cNvSpPr txBox="1"/>
            <p:nvPr/>
          </p:nvSpPr>
          <p:spPr>
            <a:xfrm>
              <a:off x="4530689" y="3585648"/>
              <a:ext cx="6801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F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CBEB9970-9574-FF4F-A36C-43E6B9C21EFF}"/>
                </a:ext>
              </a:extLst>
            </p:cNvPr>
            <p:cNvSpPr txBox="1"/>
            <p:nvPr/>
          </p:nvSpPr>
          <p:spPr>
            <a:xfrm>
              <a:off x="4545877" y="4469332"/>
              <a:ext cx="6801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PF</a:t>
              </a:r>
            </a:p>
          </p:txBody>
        </p:sp>
      </p:grpSp>
      <p:grpSp>
        <p:nvGrpSpPr>
          <p:cNvPr id="42" name="Group 41">
            <a:extLst>
              <a:ext uri="{FF2B5EF4-FFF2-40B4-BE49-F238E27FC236}">
                <a16:creationId xmlns:a16="http://schemas.microsoft.com/office/drawing/2014/main" id="{2DFEFB6D-DDC0-5948-B06B-7211C9858E0B}"/>
              </a:ext>
            </a:extLst>
          </p:cNvPr>
          <p:cNvGrpSpPr/>
          <p:nvPr/>
        </p:nvGrpSpPr>
        <p:grpSpPr>
          <a:xfrm>
            <a:off x="6186904" y="155068"/>
            <a:ext cx="4026866" cy="3288208"/>
            <a:chOff x="6371168" y="0"/>
            <a:chExt cx="4406615" cy="4087557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D34CF9A6-49EC-E549-9308-FE2886E9888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371168" y="0"/>
              <a:ext cx="4406615" cy="4087557"/>
            </a:xfrm>
            <a:prstGeom prst="rect">
              <a:avLst/>
            </a:prstGeom>
          </p:spPr>
        </p:pic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EBFB0A8A-7F09-494D-809A-EA80CA2275E6}"/>
                </a:ext>
              </a:extLst>
            </p:cNvPr>
            <p:cNvGrpSpPr/>
            <p:nvPr/>
          </p:nvGrpSpPr>
          <p:grpSpPr>
            <a:xfrm>
              <a:off x="7885545" y="2108835"/>
              <a:ext cx="2457616" cy="1429163"/>
              <a:chOff x="2834641" y="3192378"/>
              <a:chExt cx="2457616" cy="1429163"/>
            </a:xfrm>
          </p:grpSpPr>
          <p:grpSp>
            <p:nvGrpSpPr>
              <p:cNvPr id="23" name="Group 22">
                <a:extLst>
                  <a:ext uri="{FF2B5EF4-FFF2-40B4-BE49-F238E27FC236}">
                    <a16:creationId xmlns:a16="http://schemas.microsoft.com/office/drawing/2014/main" id="{78B93AE3-AFDE-A041-B619-D9B7F19037C1}"/>
                  </a:ext>
                </a:extLst>
              </p:cNvPr>
              <p:cNvGrpSpPr/>
              <p:nvPr/>
            </p:nvGrpSpPr>
            <p:grpSpPr>
              <a:xfrm>
                <a:off x="2834641" y="3566160"/>
                <a:ext cx="2457616" cy="1055381"/>
                <a:chOff x="2834641" y="3566160"/>
                <a:chExt cx="2457616" cy="1055381"/>
              </a:xfrm>
            </p:grpSpPr>
            <p:sp>
              <p:nvSpPr>
                <p:cNvPr id="25" name="Freeform 24">
                  <a:extLst>
                    <a:ext uri="{FF2B5EF4-FFF2-40B4-BE49-F238E27FC236}">
                      <a16:creationId xmlns:a16="http://schemas.microsoft.com/office/drawing/2014/main" id="{3F4A3D72-1B4A-804D-857B-C843C96AAB54}"/>
                    </a:ext>
                  </a:extLst>
                </p:cNvPr>
                <p:cNvSpPr/>
                <p:nvPr/>
              </p:nvSpPr>
              <p:spPr>
                <a:xfrm>
                  <a:off x="2834641" y="3566160"/>
                  <a:ext cx="2312126" cy="518160"/>
                </a:xfrm>
                <a:custGeom>
                  <a:avLst/>
                  <a:gdLst>
                    <a:gd name="connsiteX0" fmla="*/ 0 w 1998617"/>
                    <a:gd name="connsiteY0" fmla="*/ 117566 h 274320"/>
                    <a:gd name="connsiteX1" fmla="*/ 65314 w 1998617"/>
                    <a:gd name="connsiteY1" fmla="*/ 104503 h 274320"/>
                    <a:gd name="connsiteX2" fmla="*/ 143691 w 1998617"/>
                    <a:gd name="connsiteY2" fmla="*/ 52252 h 274320"/>
                    <a:gd name="connsiteX3" fmla="*/ 222068 w 1998617"/>
                    <a:gd name="connsiteY3" fmla="*/ 26126 h 274320"/>
                    <a:gd name="connsiteX4" fmla="*/ 261257 w 1998617"/>
                    <a:gd name="connsiteY4" fmla="*/ 13063 h 274320"/>
                    <a:gd name="connsiteX5" fmla="*/ 300445 w 1998617"/>
                    <a:gd name="connsiteY5" fmla="*/ 0 h 274320"/>
                    <a:gd name="connsiteX6" fmla="*/ 509451 w 1998617"/>
                    <a:gd name="connsiteY6" fmla="*/ 13063 h 274320"/>
                    <a:gd name="connsiteX7" fmla="*/ 574765 w 1998617"/>
                    <a:gd name="connsiteY7" fmla="*/ 26126 h 274320"/>
                    <a:gd name="connsiteX8" fmla="*/ 653142 w 1998617"/>
                    <a:gd name="connsiteY8" fmla="*/ 39189 h 274320"/>
                    <a:gd name="connsiteX9" fmla="*/ 757645 w 1998617"/>
                    <a:gd name="connsiteY9" fmla="*/ 65315 h 274320"/>
                    <a:gd name="connsiteX10" fmla="*/ 822960 w 1998617"/>
                    <a:gd name="connsiteY10" fmla="*/ 78378 h 274320"/>
                    <a:gd name="connsiteX11" fmla="*/ 875211 w 1998617"/>
                    <a:gd name="connsiteY11" fmla="*/ 91440 h 274320"/>
                    <a:gd name="connsiteX12" fmla="*/ 1254034 w 1998617"/>
                    <a:gd name="connsiteY12" fmla="*/ 117566 h 274320"/>
                    <a:gd name="connsiteX13" fmla="*/ 1515291 w 1998617"/>
                    <a:gd name="connsiteY13" fmla="*/ 143692 h 274320"/>
                    <a:gd name="connsiteX14" fmla="*/ 1776548 w 1998617"/>
                    <a:gd name="connsiteY14" fmla="*/ 169818 h 274320"/>
                    <a:gd name="connsiteX15" fmla="*/ 1854925 w 1998617"/>
                    <a:gd name="connsiteY15" fmla="*/ 195943 h 274320"/>
                    <a:gd name="connsiteX16" fmla="*/ 1894114 w 1998617"/>
                    <a:gd name="connsiteY16" fmla="*/ 209006 h 274320"/>
                    <a:gd name="connsiteX17" fmla="*/ 1933302 w 1998617"/>
                    <a:gd name="connsiteY17" fmla="*/ 235132 h 274320"/>
                    <a:gd name="connsiteX18" fmla="*/ 1972491 w 1998617"/>
                    <a:gd name="connsiteY18" fmla="*/ 248195 h 274320"/>
                    <a:gd name="connsiteX19" fmla="*/ 1998617 w 1998617"/>
                    <a:gd name="connsiteY19" fmla="*/ 274320 h 27432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</a:cxnLst>
                  <a:rect l="l" t="t" r="r" b="b"/>
                  <a:pathLst>
                    <a:path w="1998617" h="274320">
                      <a:moveTo>
                        <a:pt x="0" y="117566"/>
                      </a:moveTo>
                      <a:cubicBezTo>
                        <a:pt x="21771" y="113212"/>
                        <a:pt x="45102" y="113690"/>
                        <a:pt x="65314" y="104503"/>
                      </a:cubicBezTo>
                      <a:cubicBezTo>
                        <a:pt x="93899" y="91510"/>
                        <a:pt x="113903" y="62181"/>
                        <a:pt x="143691" y="52252"/>
                      </a:cubicBezTo>
                      <a:lnTo>
                        <a:pt x="222068" y="26126"/>
                      </a:lnTo>
                      <a:lnTo>
                        <a:pt x="261257" y="13063"/>
                      </a:lnTo>
                      <a:lnTo>
                        <a:pt x="300445" y="0"/>
                      </a:lnTo>
                      <a:cubicBezTo>
                        <a:pt x="370114" y="4354"/>
                        <a:pt x="439961" y="6445"/>
                        <a:pt x="509451" y="13063"/>
                      </a:cubicBezTo>
                      <a:cubicBezTo>
                        <a:pt x="531553" y="15168"/>
                        <a:pt x="552921" y="22154"/>
                        <a:pt x="574765" y="26126"/>
                      </a:cubicBezTo>
                      <a:cubicBezTo>
                        <a:pt x="600824" y="30864"/>
                        <a:pt x="627244" y="33639"/>
                        <a:pt x="653142" y="39189"/>
                      </a:cubicBezTo>
                      <a:cubicBezTo>
                        <a:pt x="688251" y="46713"/>
                        <a:pt x="722436" y="58273"/>
                        <a:pt x="757645" y="65315"/>
                      </a:cubicBezTo>
                      <a:cubicBezTo>
                        <a:pt x="779417" y="69669"/>
                        <a:pt x="801286" y="73562"/>
                        <a:pt x="822960" y="78378"/>
                      </a:cubicBezTo>
                      <a:cubicBezTo>
                        <a:pt x="840485" y="82272"/>
                        <a:pt x="857467" y="88710"/>
                        <a:pt x="875211" y="91440"/>
                      </a:cubicBezTo>
                      <a:cubicBezTo>
                        <a:pt x="1002504" y="111023"/>
                        <a:pt x="1123526" y="109409"/>
                        <a:pt x="1254034" y="117566"/>
                      </a:cubicBezTo>
                      <a:cubicBezTo>
                        <a:pt x="1536291" y="135207"/>
                        <a:pt x="1298155" y="123012"/>
                        <a:pt x="1515291" y="143692"/>
                      </a:cubicBezTo>
                      <a:cubicBezTo>
                        <a:pt x="1792928" y="170134"/>
                        <a:pt x="1587081" y="142751"/>
                        <a:pt x="1776548" y="169818"/>
                      </a:cubicBezTo>
                      <a:lnTo>
                        <a:pt x="1854925" y="195943"/>
                      </a:lnTo>
                      <a:lnTo>
                        <a:pt x="1894114" y="209006"/>
                      </a:lnTo>
                      <a:cubicBezTo>
                        <a:pt x="1907177" y="217715"/>
                        <a:pt x="1919260" y="228111"/>
                        <a:pt x="1933302" y="235132"/>
                      </a:cubicBezTo>
                      <a:cubicBezTo>
                        <a:pt x="1945618" y="241290"/>
                        <a:pt x="1960684" y="241111"/>
                        <a:pt x="1972491" y="248195"/>
                      </a:cubicBezTo>
                      <a:cubicBezTo>
                        <a:pt x="1983052" y="254531"/>
                        <a:pt x="1989908" y="265612"/>
                        <a:pt x="1998617" y="274320"/>
                      </a:cubicBezTo>
                    </a:path>
                  </a:pathLst>
                </a:custGeom>
                <a:noFill/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26" name="Freeform 25">
                  <a:extLst>
                    <a:ext uri="{FF2B5EF4-FFF2-40B4-BE49-F238E27FC236}">
                      <a16:creationId xmlns:a16="http://schemas.microsoft.com/office/drawing/2014/main" id="{5A36C672-F1BE-B74F-966B-4B810B0FB4C4}"/>
                    </a:ext>
                  </a:extLst>
                </p:cNvPr>
                <p:cNvSpPr/>
                <p:nvPr/>
              </p:nvSpPr>
              <p:spPr>
                <a:xfrm>
                  <a:off x="3853543" y="3735976"/>
                  <a:ext cx="1438714" cy="885565"/>
                </a:xfrm>
                <a:custGeom>
                  <a:avLst/>
                  <a:gdLst>
                    <a:gd name="connsiteX0" fmla="*/ 0 w 1645920"/>
                    <a:gd name="connsiteY0" fmla="*/ 0 h 1084218"/>
                    <a:gd name="connsiteX1" fmla="*/ 65314 w 1645920"/>
                    <a:gd name="connsiteY1" fmla="*/ 52252 h 1084218"/>
                    <a:gd name="connsiteX2" fmla="*/ 104503 w 1645920"/>
                    <a:gd name="connsiteY2" fmla="*/ 78378 h 1084218"/>
                    <a:gd name="connsiteX3" fmla="*/ 182880 w 1645920"/>
                    <a:gd name="connsiteY3" fmla="*/ 143692 h 1084218"/>
                    <a:gd name="connsiteX4" fmla="*/ 209006 w 1645920"/>
                    <a:gd name="connsiteY4" fmla="*/ 182880 h 1084218"/>
                    <a:gd name="connsiteX5" fmla="*/ 287383 w 1645920"/>
                    <a:gd name="connsiteY5" fmla="*/ 235132 h 1084218"/>
                    <a:gd name="connsiteX6" fmla="*/ 352697 w 1645920"/>
                    <a:gd name="connsiteY6" fmla="*/ 313509 h 1084218"/>
                    <a:gd name="connsiteX7" fmla="*/ 404949 w 1645920"/>
                    <a:gd name="connsiteY7" fmla="*/ 391886 h 1084218"/>
                    <a:gd name="connsiteX8" fmla="*/ 431074 w 1645920"/>
                    <a:gd name="connsiteY8" fmla="*/ 431075 h 1084218"/>
                    <a:gd name="connsiteX9" fmla="*/ 470263 w 1645920"/>
                    <a:gd name="connsiteY9" fmla="*/ 457200 h 1084218"/>
                    <a:gd name="connsiteX10" fmla="*/ 561703 w 1645920"/>
                    <a:gd name="connsiteY10" fmla="*/ 561703 h 1084218"/>
                    <a:gd name="connsiteX11" fmla="*/ 627017 w 1645920"/>
                    <a:gd name="connsiteY11" fmla="*/ 627018 h 1084218"/>
                    <a:gd name="connsiteX12" fmla="*/ 653143 w 1645920"/>
                    <a:gd name="connsiteY12" fmla="*/ 666206 h 1084218"/>
                    <a:gd name="connsiteX13" fmla="*/ 731520 w 1645920"/>
                    <a:gd name="connsiteY13" fmla="*/ 718458 h 1084218"/>
                    <a:gd name="connsiteX14" fmla="*/ 757646 w 1645920"/>
                    <a:gd name="connsiteY14" fmla="*/ 757646 h 1084218"/>
                    <a:gd name="connsiteX15" fmla="*/ 901337 w 1645920"/>
                    <a:gd name="connsiteY15" fmla="*/ 836023 h 1084218"/>
                    <a:gd name="connsiteX16" fmla="*/ 953589 w 1645920"/>
                    <a:gd name="connsiteY16" fmla="*/ 862149 h 1084218"/>
                    <a:gd name="connsiteX17" fmla="*/ 992777 w 1645920"/>
                    <a:gd name="connsiteY17" fmla="*/ 888275 h 1084218"/>
                    <a:gd name="connsiteX18" fmla="*/ 1123406 w 1645920"/>
                    <a:gd name="connsiteY18" fmla="*/ 914400 h 1084218"/>
                    <a:gd name="connsiteX19" fmla="*/ 1397726 w 1645920"/>
                    <a:gd name="connsiteY19" fmla="*/ 940526 h 1084218"/>
                    <a:gd name="connsiteX20" fmla="*/ 1476103 w 1645920"/>
                    <a:gd name="connsiteY20" fmla="*/ 966652 h 1084218"/>
                    <a:gd name="connsiteX21" fmla="*/ 1515292 w 1645920"/>
                    <a:gd name="connsiteY21" fmla="*/ 979715 h 1084218"/>
                    <a:gd name="connsiteX22" fmla="*/ 1593669 w 1645920"/>
                    <a:gd name="connsiteY22" fmla="*/ 1031966 h 1084218"/>
                    <a:gd name="connsiteX23" fmla="*/ 1645920 w 1645920"/>
                    <a:gd name="connsiteY23" fmla="*/ 1084218 h 108421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</a:cxnLst>
                  <a:rect l="l" t="t" r="r" b="b"/>
                  <a:pathLst>
                    <a:path w="1645920" h="1084218">
                      <a:moveTo>
                        <a:pt x="0" y="0"/>
                      </a:moveTo>
                      <a:cubicBezTo>
                        <a:pt x="21771" y="17417"/>
                        <a:pt x="43009" y="35523"/>
                        <a:pt x="65314" y="52252"/>
                      </a:cubicBezTo>
                      <a:cubicBezTo>
                        <a:pt x="77874" y="61672"/>
                        <a:pt x="92442" y="68327"/>
                        <a:pt x="104503" y="78378"/>
                      </a:cubicBezTo>
                      <a:cubicBezTo>
                        <a:pt x="205089" y="162198"/>
                        <a:pt x="85578" y="78823"/>
                        <a:pt x="182880" y="143692"/>
                      </a:cubicBezTo>
                      <a:cubicBezTo>
                        <a:pt x="191589" y="156755"/>
                        <a:pt x="197191" y="172542"/>
                        <a:pt x="209006" y="182880"/>
                      </a:cubicBezTo>
                      <a:cubicBezTo>
                        <a:pt x="232636" y="203557"/>
                        <a:pt x="287383" y="235132"/>
                        <a:pt x="287383" y="235132"/>
                      </a:cubicBezTo>
                      <a:cubicBezTo>
                        <a:pt x="380746" y="375173"/>
                        <a:pt x="235348" y="162631"/>
                        <a:pt x="352697" y="313509"/>
                      </a:cubicBezTo>
                      <a:cubicBezTo>
                        <a:pt x="371974" y="338294"/>
                        <a:pt x="387532" y="365760"/>
                        <a:pt x="404949" y="391886"/>
                      </a:cubicBezTo>
                      <a:cubicBezTo>
                        <a:pt x="413658" y="404949"/>
                        <a:pt x="418011" y="422367"/>
                        <a:pt x="431074" y="431075"/>
                      </a:cubicBezTo>
                      <a:lnTo>
                        <a:pt x="470263" y="457200"/>
                      </a:lnTo>
                      <a:cubicBezTo>
                        <a:pt x="531222" y="548641"/>
                        <a:pt x="496388" y="518161"/>
                        <a:pt x="561703" y="561703"/>
                      </a:cubicBezTo>
                      <a:cubicBezTo>
                        <a:pt x="631370" y="666204"/>
                        <a:pt x="539934" y="539935"/>
                        <a:pt x="627017" y="627018"/>
                      </a:cubicBezTo>
                      <a:cubicBezTo>
                        <a:pt x="638118" y="638119"/>
                        <a:pt x="641328" y="655868"/>
                        <a:pt x="653143" y="666206"/>
                      </a:cubicBezTo>
                      <a:cubicBezTo>
                        <a:pt x="676773" y="686883"/>
                        <a:pt x="731520" y="718458"/>
                        <a:pt x="731520" y="718458"/>
                      </a:cubicBezTo>
                      <a:cubicBezTo>
                        <a:pt x="740229" y="731521"/>
                        <a:pt x="746545" y="746545"/>
                        <a:pt x="757646" y="757646"/>
                      </a:cubicBezTo>
                      <a:cubicBezTo>
                        <a:pt x="781513" y="781513"/>
                        <a:pt x="901185" y="835947"/>
                        <a:pt x="901337" y="836023"/>
                      </a:cubicBezTo>
                      <a:cubicBezTo>
                        <a:pt x="918754" y="844732"/>
                        <a:pt x="937386" y="851347"/>
                        <a:pt x="953589" y="862149"/>
                      </a:cubicBezTo>
                      <a:cubicBezTo>
                        <a:pt x="966652" y="870858"/>
                        <a:pt x="977772" y="883658"/>
                        <a:pt x="992777" y="888275"/>
                      </a:cubicBezTo>
                      <a:cubicBezTo>
                        <a:pt x="1035219" y="901334"/>
                        <a:pt x="1079863" y="905692"/>
                        <a:pt x="1123406" y="914400"/>
                      </a:cubicBezTo>
                      <a:cubicBezTo>
                        <a:pt x="1257175" y="941153"/>
                        <a:pt x="1166542" y="926077"/>
                        <a:pt x="1397726" y="940526"/>
                      </a:cubicBezTo>
                      <a:lnTo>
                        <a:pt x="1476103" y="966652"/>
                      </a:lnTo>
                      <a:cubicBezTo>
                        <a:pt x="1489166" y="971006"/>
                        <a:pt x="1503835" y="972077"/>
                        <a:pt x="1515292" y="979715"/>
                      </a:cubicBezTo>
                      <a:lnTo>
                        <a:pt x="1593669" y="1031966"/>
                      </a:lnTo>
                      <a:cubicBezTo>
                        <a:pt x="1640958" y="1063492"/>
                        <a:pt x="1625836" y="1044051"/>
                        <a:pt x="1645920" y="1084218"/>
                      </a:cubicBezTo>
                    </a:path>
                  </a:pathLst>
                </a:custGeom>
                <a:noFill/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sp>
            <p:nvSpPr>
              <p:cNvPr id="24" name="Freeform 23">
                <a:extLst>
                  <a:ext uri="{FF2B5EF4-FFF2-40B4-BE49-F238E27FC236}">
                    <a16:creationId xmlns:a16="http://schemas.microsoft.com/office/drawing/2014/main" id="{D298BDEC-0617-D84F-A35C-FC64D96E5002}"/>
                  </a:ext>
                </a:extLst>
              </p:cNvPr>
              <p:cNvSpPr/>
              <p:nvPr/>
            </p:nvSpPr>
            <p:spPr>
              <a:xfrm rot="8200495">
                <a:off x="3430594" y="3192378"/>
                <a:ext cx="861517" cy="504350"/>
              </a:xfrm>
              <a:custGeom>
                <a:avLst/>
                <a:gdLst>
                  <a:gd name="connsiteX0" fmla="*/ 0 w 1645920"/>
                  <a:gd name="connsiteY0" fmla="*/ 0 h 1084218"/>
                  <a:gd name="connsiteX1" fmla="*/ 65314 w 1645920"/>
                  <a:gd name="connsiteY1" fmla="*/ 52252 h 1084218"/>
                  <a:gd name="connsiteX2" fmla="*/ 104503 w 1645920"/>
                  <a:gd name="connsiteY2" fmla="*/ 78378 h 1084218"/>
                  <a:gd name="connsiteX3" fmla="*/ 182880 w 1645920"/>
                  <a:gd name="connsiteY3" fmla="*/ 143692 h 1084218"/>
                  <a:gd name="connsiteX4" fmla="*/ 209006 w 1645920"/>
                  <a:gd name="connsiteY4" fmla="*/ 182880 h 1084218"/>
                  <a:gd name="connsiteX5" fmla="*/ 287383 w 1645920"/>
                  <a:gd name="connsiteY5" fmla="*/ 235132 h 1084218"/>
                  <a:gd name="connsiteX6" fmla="*/ 352697 w 1645920"/>
                  <a:gd name="connsiteY6" fmla="*/ 313509 h 1084218"/>
                  <a:gd name="connsiteX7" fmla="*/ 404949 w 1645920"/>
                  <a:gd name="connsiteY7" fmla="*/ 391886 h 1084218"/>
                  <a:gd name="connsiteX8" fmla="*/ 431074 w 1645920"/>
                  <a:gd name="connsiteY8" fmla="*/ 431075 h 1084218"/>
                  <a:gd name="connsiteX9" fmla="*/ 470263 w 1645920"/>
                  <a:gd name="connsiteY9" fmla="*/ 457200 h 1084218"/>
                  <a:gd name="connsiteX10" fmla="*/ 561703 w 1645920"/>
                  <a:gd name="connsiteY10" fmla="*/ 561703 h 1084218"/>
                  <a:gd name="connsiteX11" fmla="*/ 627017 w 1645920"/>
                  <a:gd name="connsiteY11" fmla="*/ 627018 h 1084218"/>
                  <a:gd name="connsiteX12" fmla="*/ 653143 w 1645920"/>
                  <a:gd name="connsiteY12" fmla="*/ 666206 h 1084218"/>
                  <a:gd name="connsiteX13" fmla="*/ 731520 w 1645920"/>
                  <a:gd name="connsiteY13" fmla="*/ 718458 h 1084218"/>
                  <a:gd name="connsiteX14" fmla="*/ 757646 w 1645920"/>
                  <a:gd name="connsiteY14" fmla="*/ 757646 h 1084218"/>
                  <a:gd name="connsiteX15" fmla="*/ 901337 w 1645920"/>
                  <a:gd name="connsiteY15" fmla="*/ 836023 h 1084218"/>
                  <a:gd name="connsiteX16" fmla="*/ 953589 w 1645920"/>
                  <a:gd name="connsiteY16" fmla="*/ 862149 h 1084218"/>
                  <a:gd name="connsiteX17" fmla="*/ 992777 w 1645920"/>
                  <a:gd name="connsiteY17" fmla="*/ 888275 h 1084218"/>
                  <a:gd name="connsiteX18" fmla="*/ 1123406 w 1645920"/>
                  <a:gd name="connsiteY18" fmla="*/ 914400 h 1084218"/>
                  <a:gd name="connsiteX19" fmla="*/ 1397726 w 1645920"/>
                  <a:gd name="connsiteY19" fmla="*/ 940526 h 1084218"/>
                  <a:gd name="connsiteX20" fmla="*/ 1476103 w 1645920"/>
                  <a:gd name="connsiteY20" fmla="*/ 966652 h 1084218"/>
                  <a:gd name="connsiteX21" fmla="*/ 1515292 w 1645920"/>
                  <a:gd name="connsiteY21" fmla="*/ 979715 h 1084218"/>
                  <a:gd name="connsiteX22" fmla="*/ 1593669 w 1645920"/>
                  <a:gd name="connsiteY22" fmla="*/ 1031966 h 1084218"/>
                  <a:gd name="connsiteX23" fmla="*/ 1645920 w 1645920"/>
                  <a:gd name="connsiteY23" fmla="*/ 1084218 h 1084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</a:cxnLst>
                <a:rect l="l" t="t" r="r" b="b"/>
                <a:pathLst>
                  <a:path w="1645920" h="1084218">
                    <a:moveTo>
                      <a:pt x="0" y="0"/>
                    </a:moveTo>
                    <a:cubicBezTo>
                      <a:pt x="21771" y="17417"/>
                      <a:pt x="43009" y="35523"/>
                      <a:pt x="65314" y="52252"/>
                    </a:cubicBezTo>
                    <a:cubicBezTo>
                      <a:pt x="77874" y="61672"/>
                      <a:pt x="92442" y="68327"/>
                      <a:pt x="104503" y="78378"/>
                    </a:cubicBezTo>
                    <a:cubicBezTo>
                      <a:pt x="205089" y="162198"/>
                      <a:pt x="85578" y="78823"/>
                      <a:pt x="182880" y="143692"/>
                    </a:cubicBezTo>
                    <a:cubicBezTo>
                      <a:pt x="191589" y="156755"/>
                      <a:pt x="197191" y="172542"/>
                      <a:pt x="209006" y="182880"/>
                    </a:cubicBezTo>
                    <a:cubicBezTo>
                      <a:pt x="232636" y="203557"/>
                      <a:pt x="287383" y="235132"/>
                      <a:pt x="287383" y="235132"/>
                    </a:cubicBezTo>
                    <a:cubicBezTo>
                      <a:pt x="380746" y="375173"/>
                      <a:pt x="235348" y="162631"/>
                      <a:pt x="352697" y="313509"/>
                    </a:cubicBezTo>
                    <a:cubicBezTo>
                      <a:pt x="371974" y="338294"/>
                      <a:pt x="387532" y="365760"/>
                      <a:pt x="404949" y="391886"/>
                    </a:cubicBezTo>
                    <a:cubicBezTo>
                      <a:pt x="413658" y="404949"/>
                      <a:pt x="418011" y="422367"/>
                      <a:pt x="431074" y="431075"/>
                    </a:cubicBezTo>
                    <a:lnTo>
                      <a:pt x="470263" y="457200"/>
                    </a:lnTo>
                    <a:cubicBezTo>
                      <a:pt x="531222" y="548641"/>
                      <a:pt x="496388" y="518161"/>
                      <a:pt x="561703" y="561703"/>
                    </a:cubicBezTo>
                    <a:cubicBezTo>
                      <a:pt x="631370" y="666204"/>
                      <a:pt x="539934" y="539935"/>
                      <a:pt x="627017" y="627018"/>
                    </a:cubicBezTo>
                    <a:cubicBezTo>
                      <a:pt x="638118" y="638119"/>
                      <a:pt x="641328" y="655868"/>
                      <a:pt x="653143" y="666206"/>
                    </a:cubicBezTo>
                    <a:cubicBezTo>
                      <a:pt x="676773" y="686883"/>
                      <a:pt x="731520" y="718458"/>
                      <a:pt x="731520" y="718458"/>
                    </a:cubicBezTo>
                    <a:cubicBezTo>
                      <a:pt x="740229" y="731521"/>
                      <a:pt x="746545" y="746545"/>
                      <a:pt x="757646" y="757646"/>
                    </a:cubicBezTo>
                    <a:cubicBezTo>
                      <a:pt x="781513" y="781513"/>
                      <a:pt x="901185" y="835947"/>
                      <a:pt x="901337" y="836023"/>
                    </a:cubicBezTo>
                    <a:cubicBezTo>
                      <a:pt x="918754" y="844732"/>
                      <a:pt x="937386" y="851347"/>
                      <a:pt x="953589" y="862149"/>
                    </a:cubicBezTo>
                    <a:cubicBezTo>
                      <a:pt x="966652" y="870858"/>
                      <a:pt x="977772" y="883658"/>
                      <a:pt x="992777" y="888275"/>
                    </a:cubicBezTo>
                    <a:cubicBezTo>
                      <a:pt x="1035219" y="901334"/>
                      <a:pt x="1079863" y="905692"/>
                      <a:pt x="1123406" y="914400"/>
                    </a:cubicBezTo>
                    <a:cubicBezTo>
                      <a:pt x="1257175" y="941153"/>
                      <a:pt x="1166542" y="926077"/>
                      <a:pt x="1397726" y="940526"/>
                    </a:cubicBezTo>
                    <a:lnTo>
                      <a:pt x="1476103" y="966652"/>
                    </a:lnTo>
                    <a:cubicBezTo>
                      <a:pt x="1489166" y="971006"/>
                      <a:pt x="1503835" y="972077"/>
                      <a:pt x="1515292" y="979715"/>
                    </a:cubicBezTo>
                    <a:lnTo>
                      <a:pt x="1593669" y="1031966"/>
                    </a:lnTo>
                    <a:cubicBezTo>
                      <a:pt x="1640958" y="1063492"/>
                      <a:pt x="1625836" y="1044051"/>
                      <a:pt x="1645920" y="1084218"/>
                    </a:cubicBezTo>
                  </a:path>
                </a:pathLst>
              </a:cu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63B88D89-6DAA-6B4F-BC37-3A907733E7A4}"/>
                </a:ext>
              </a:extLst>
            </p:cNvPr>
            <p:cNvGrpSpPr/>
            <p:nvPr/>
          </p:nvGrpSpPr>
          <p:grpSpPr>
            <a:xfrm>
              <a:off x="7740055" y="1952559"/>
              <a:ext cx="2138506" cy="1633426"/>
              <a:chOff x="3087525" y="3143683"/>
              <a:chExt cx="2138506" cy="1633426"/>
            </a:xfrm>
          </p:grpSpPr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986AA973-E58E-4240-8446-E5C547803E14}"/>
                  </a:ext>
                </a:extLst>
              </p:cNvPr>
              <p:cNvSpPr txBox="1"/>
              <p:nvPr/>
            </p:nvSpPr>
            <p:spPr>
              <a:xfrm>
                <a:off x="3087525" y="3392328"/>
                <a:ext cx="68015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B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6BB9EE6B-7F6F-0D44-93C4-127BEA00C7FD}"/>
                  </a:ext>
                </a:extLst>
              </p:cNvPr>
              <p:cNvSpPr txBox="1"/>
              <p:nvPr/>
            </p:nvSpPr>
            <p:spPr>
              <a:xfrm>
                <a:off x="3590904" y="3726469"/>
                <a:ext cx="68015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B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48D54ACB-29A5-DD45-B02D-A73454A2AFB5}"/>
                  </a:ext>
                </a:extLst>
              </p:cNvPr>
              <p:cNvSpPr txBox="1"/>
              <p:nvPr/>
            </p:nvSpPr>
            <p:spPr>
              <a:xfrm>
                <a:off x="3714070" y="3143683"/>
                <a:ext cx="68015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B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532F5762-A1A4-3941-B1A7-5D9965AF50DC}"/>
                  </a:ext>
                </a:extLst>
              </p:cNvPr>
              <p:cNvSpPr txBox="1"/>
              <p:nvPr/>
            </p:nvSpPr>
            <p:spPr>
              <a:xfrm>
                <a:off x="4530689" y="3585648"/>
                <a:ext cx="68015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F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2CDF6396-03A0-F945-96B6-0B7E571B7F68}"/>
                  </a:ext>
                </a:extLst>
              </p:cNvPr>
              <p:cNvSpPr txBox="1"/>
              <p:nvPr/>
            </p:nvSpPr>
            <p:spPr>
              <a:xfrm>
                <a:off x="4545877" y="4469332"/>
                <a:ext cx="68015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PF</a:t>
                </a:r>
              </a:p>
            </p:txBody>
          </p:sp>
        </p:grpSp>
      </p:grpSp>
      <p:pic>
        <p:nvPicPr>
          <p:cNvPr id="40" name="Picture 39">
            <a:extLst>
              <a:ext uri="{FF2B5EF4-FFF2-40B4-BE49-F238E27FC236}">
                <a16:creationId xmlns:a16="http://schemas.microsoft.com/office/drawing/2014/main" id="{F0EF78EC-B4C1-2641-8F65-788C410C11A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67484" y="3540708"/>
            <a:ext cx="4033710" cy="3317291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D5ECD1C-AE01-AC45-AA94-65E87CC336E6}"/>
              </a:ext>
            </a:extLst>
          </p:cNvPr>
          <p:cNvSpPr txBox="1"/>
          <p:nvPr/>
        </p:nvSpPr>
        <p:spPr>
          <a:xfrm>
            <a:off x="2148673" y="526748"/>
            <a:ext cx="5346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BEE3709-0CA0-504E-ACAE-708153548B5E}"/>
              </a:ext>
            </a:extLst>
          </p:cNvPr>
          <p:cNvSpPr txBox="1"/>
          <p:nvPr/>
        </p:nvSpPr>
        <p:spPr>
          <a:xfrm>
            <a:off x="6253917" y="526748"/>
            <a:ext cx="5346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B33347F-1781-7B4F-8D39-09F7FE629E8A}"/>
              </a:ext>
            </a:extLst>
          </p:cNvPr>
          <p:cNvSpPr txBox="1"/>
          <p:nvPr/>
        </p:nvSpPr>
        <p:spPr>
          <a:xfrm>
            <a:off x="1648856" y="134814"/>
            <a:ext cx="431938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0117275F-432F-E64F-B204-841338843A89}"/>
              </a:ext>
            </a:extLst>
          </p:cNvPr>
          <p:cNvSpPr txBox="1"/>
          <p:nvPr/>
        </p:nvSpPr>
        <p:spPr>
          <a:xfrm>
            <a:off x="2067484" y="3540708"/>
            <a:ext cx="5346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grpSp>
        <p:nvGrpSpPr>
          <p:cNvPr id="44" name="Group 43">
            <a:extLst>
              <a:ext uri="{FF2B5EF4-FFF2-40B4-BE49-F238E27FC236}">
                <a16:creationId xmlns:a16="http://schemas.microsoft.com/office/drawing/2014/main" id="{18CCF4C0-5947-D841-AD33-458CAC43AC55}"/>
              </a:ext>
            </a:extLst>
          </p:cNvPr>
          <p:cNvGrpSpPr/>
          <p:nvPr/>
        </p:nvGrpSpPr>
        <p:grpSpPr>
          <a:xfrm>
            <a:off x="3627413" y="5073571"/>
            <a:ext cx="2169376" cy="1317201"/>
            <a:chOff x="7437824" y="1725791"/>
            <a:chExt cx="2378778" cy="1313999"/>
          </a:xfrm>
        </p:grpSpPr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9844B4D5-14AD-8141-B2C8-936B14711AFD}"/>
                </a:ext>
              </a:extLst>
            </p:cNvPr>
            <p:cNvGrpSpPr/>
            <p:nvPr/>
          </p:nvGrpSpPr>
          <p:grpSpPr>
            <a:xfrm>
              <a:off x="7570776" y="1861470"/>
              <a:ext cx="2245826" cy="1139718"/>
              <a:chOff x="2834641" y="3204763"/>
              <a:chExt cx="2457616" cy="1416778"/>
            </a:xfrm>
          </p:grpSpPr>
          <p:grpSp>
            <p:nvGrpSpPr>
              <p:cNvPr id="52" name="Group 51">
                <a:extLst>
                  <a:ext uri="{FF2B5EF4-FFF2-40B4-BE49-F238E27FC236}">
                    <a16:creationId xmlns:a16="http://schemas.microsoft.com/office/drawing/2014/main" id="{47AB1101-C014-A44E-88A4-679E5C10B80F}"/>
                  </a:ext>
                </a:extLst>
              </p:cNvPr>
              <p:cNvGrpSpPr/>
              <p:nvPr/>
            </p:nvGrpSpPr>
            <p:grpSpPr>
              <a:xfrm>
                <a:off x="2834641" y="3566160"/>
                <a:ext cx="2457616" cy="1055381"/>
                <a:chOff x="2834641" y="3566160"/>
                <a:chExt cx="2457616" cy="1055381"/>
              </a:xfrm>
            </p:grpSpPr>
            <p:sp>
              <p:nvSpPr>
                <p:cNvPr id="54" name="Freeform 53">
                  <a:extLst>
                    <a:ext uri="{FF2B5EF4-FFF2-40B4-BE49-F238E27FC236}">
                      <a16:creationId xmlns:a16="http://schemas.microsoft.com/office/drawing/2014/main" id="{3D4D0868-5D99-814F-AAEE-6F4C4B401385}"/>
                    </a:ext>
                  </a:extLst>
                </p:cNvPr>
                <p:cNvSpPr/>
                <p:nvPr/>
              </p:nvSpPr>
              <p:spPr>
                <a:xfrm>
                  <a:off x="2834641" y="3566160"/>
                  <a:ext cx="2312126" cy="518160"/>
                </a:xfrm>
                <a:custGeom>
                  <a:avLst/>
                  <a:gdLst>
                    <a:gd name="connsiteX0" fmla="*/ 0 w 1998617"/>
                    <a:gd name="connsiteY0" fmla="*/ 117566 h 274320"/>
                    <a:gd name="connsiteX1" fmla="*/ 65314 w 1998617"/>
                    <a:gd name="connsiteY1" fmla="*/ 104503 h 274320"/>
                    <a:gd name="connsiteX2" fmla="*/ 143691 w 1998617"/>
                    <a:gd name="connsiteY2" fmla="*/ 52252 h 274320"/>
                    <a:gd name="connsiteX3" fmla="*/ 222068 w 1998617"/>
                    <a:gd name="connsiteY3" fmla="*/ 26126 h 274320"/>
                    <a:gd name="connsiteX4" fmla="*/ 261257 w 1998617"/>
                    <a:gd name="connsiteY4" fmla="*/ 13063 h 274320"/>
                    <a:gd name="connsiteX5" fmla="*/ 300445 w 1998617"/>
                    <a:gd name="connsiteY5" fmla="*/ 0 h 274320"/>
                    <a:gd name="connsiteX6" fmla="*/ 509451 w 1998617"/>
                    <a:gd name="connsiteY6" fmla="*/ 13063 h 274320"/>
                    <a:gd name="connsiteX7" fmla="*/ 574765 w 1998617"/>
                    <a:gd name="connsiteY7" fmla="*/ 26126 h 274320"/>
                    <a:gd name="connsiteX8" fmla="*/ 653142 w 1998617"/>
                    <a:gd name="connsiteY8" fmla="*/ 39189 h 274320"/>
                    <a:gd name="connsiteX9" fmla="*/ 757645 w 1998617"/>
                    <a:gd name="connsiteY9" fmla="*/ 65315 h 274320"/>
                    <a:gd name="connsiteX10" fmla="*/ 822960 w 1998617"/>
                    <a:gd name="connsiteY10" fmla="*/ 78378 h 274320"/>
                    <a:gd name="connsiteX11" fmla="*/ 875211 w 1998617"/>
                    <a:gd name="connsiteY11" fmla="*/ 91440 h 274320"/>
                    <a:gd name="connsiteX12" fmla="*/ 1254034 w 1998617"/>
                    <a:gd name="connsiteY12" fmla="*/ 117566 h 274320"/>
                    <a:gd name="connsiteX13" fmla="*/ 1515291 w 1998617"/>
                    <a:gd name="connsiteY13" fmla="*/ 143692 h 274320"/>
                    <a:gd name="connsiteX14" fmla="*/ 1776548 w 1998617"/>
                    <a:gd name="connsiteY14" fmla="*/ 169818 h 274320"/>
                    <a:gd name="connsiteX15" fmla="*/ 1854925 w 1998617"/>
                    <a:gd name="connsiteY15" fmla="*/ 195943 h 274320"/>
                    <a:gd name="connsiteX16" fmla="*/ 1894114 w 1998617"/>
                    <a:gd name="connsiteY16" fmla="*/ 209006 h 274320"/>
                    <a:gd name="connsiteX17" fmla="*/ 1933302 w 1998617"/>
                    <a:gd name="connsiteY17" fmla="*/ 235132 h 274320"/>
                    <a:gd name="connsiteX18" fmla="*/ 1972491 w 1998617"/>
                    <a:gd name="connsiteY18" fmla="*/ 248195 h 274320"/>
                    <a:gd name="connsiteX19" fmla="*/ 1998617 w 1998617"/>
                    <a:gd name="connsiteY19" fmla="*/ 274320 h 274320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</a:cxnLst>
                  <a:rect l="l" t="t" r="r" b="b"/>
                  <a:pathLst>
                    <a:path w="1998617" h="274320">
                      <a:moveTo>
                        <a:pt x="0" y="117566"/>
                      </a:moveTo>
                      <a:cubicBezTo>
                        <a:pt x="21771" y="113212"/>
                        <a:pt x="45102" y="113690"/>
                        <a:pt x="65314" y="104503"/>
                      </a:cubicBezTo>
                      <a:cubicBezTo>
                        <a:pt x="93899" y="91510"/>
                        <a:pt x="113903" y="62181"/>
                        <a:pt x="143691" y="52252"/>
                      </a:cubicBezTo>
                      <a:lnTo>
                        <a:pt x="222068" y="26126"/>
                      </a:lnTo>
                      <a:lnTo>
                        <a:pt x="261257" y="13063"/>
                      </a:lnTo>
                      <a:lnTo>
                        <a:pt x="300445" y="0"/>
                      </a:lnTo>
                      <a:cubicBezTo>
                        <a:pt x="370114" y="4354"/>
                        <a:pt x="439961" y="6445"/>
                        <a:pt x="509451" y="13063"/>
                      </a:cubicBezTo>
                      <a:cubicBezTo>
                        <a:pt x="531553" y="15168"/>
                        <a:pt x="552921" y="22154"/>
                        <a:pt x="574765" y="26126"/>
                      </a:cubicBezTo>
                      <a:cubicBezTo>
                        <a:pt x="600824" y="30864"/>
                        <a:pt x="627244" y="33639"/>
                        <a:pt x="653142" y="39189"/>
                      </a:cubicBezTo>
                      <a:cubicBezTo>
                        <a:pt x="688251" y="46713"/>
                        <a:pt x="722436" y="58273"/>
                        <a:pt x="757645" y="65315"/>
                      </a:cubicBezTo>
                      <a:cubicBezTo>
                        <a:pt x="779417" y="69669"/>
                        <a:pt x="801286" y="73562"/>
                        <a:pt x="822960" y="78378"/>
                      </a:cubicBezTo>
                      <a:cubicBezTo>
                        <a:pt x="840485" y="82272"/>
                        <a:pt x="857467" y="88710"/>
                        <a:pt x="875211" y="91440"/>
                      </a:cubicBezTo>
                      <a:cubicBezTo>
                        <a:pt x="1002504" y="111023"/>
                        <a:pt x="1123526" y="109409"/>
                        <a:pt x="1254034" y="117566"/>
                      </a:cubicBezTo>
                      <a:cubicBezTo>
                        <a:pt x="1536291" y="135207"/>
                        <a:pt x="1298155" y="123012"/>
                        <a:pt x="1515291" y="143692"/>
                      </a:cubicBezTo>
                      <a:cubicBezTo>
                        <a:pt x="1792928" y="170134"/>
                        <a:pt x="1587081" y="142751"/>
                        <a:pt x="1776548" y="169818"/>
                      </a:cubicBezTo>
                      <a:lnTo>
                        <a:pt x="1854925" y="195943"/>
                      </a:lnTo>
                      <a:lnTo>
                        <a:pt x="1894114" y="209006"/>
                      </a:lnTo>
                      <a:cubicBezTo>
                        <a:pt x="1907177" y="217715"/>
                        <a:pt x="1919260" y="228111"/>
                        <a:pt x="1933302" y="235132"/>
                      </a:cubicBezTo>
                      <a:cubicBezTo>
                        <a:pt x="1945618" y="241290"/>
                        <a:pt x="1960684" y="241111"/>
                        <a:pt x="1972491" y="248195"/>
                      </a:cubicBezTo>
                      <a:cubicBezTo>
                        <a:pt x="1983052" y="254531"/>
                        <a:pt x="1989908" y="265612"/>
                        <a:pt x="1998617" y="274320"/>
                      </a:cubicBezTo>
                    </a:path>
                  </a:pathLst>
                </a:custGeom>
                <a:noFill/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55" name="Freeform 54">
                  <a:extLst>
                    <a:ext uri="{FF2B5EF4-FFF2-40B4-BE49-F238E27FC236}">
                      <a16:creationId xmlns:a16="http://schemas.microsoft.com/office/drawing/2014/main" id="{30C80526-49DA-8746-AC6A-DFE8F97622FE}"/>
                    </a:ext>
                  </a:extLst>
                </p:cNvPr>
                <p:cNvSpPr/>
                <p:nvPr/>
              </p:nvSpPr>
              <p:spPr>
                <a:xfrm>
                  <a:off x="3853543" y="3735976"/>
                  <a:ext cx="1438714" cy="885565"/>
                </a:xfrm>
                <a:custGeom>
                  <a:avLst/>
                  <a:gdLst>
                    <a:gd name="connsiteX0" fmla="*/ 0 w 1645920"/>
                    <a:gd name="connsiteY0" fmla="*/ 0 h 1084218"/>
                    <a:gd name="connsiteX1" fmla="*/ 65314 w 1645920"/>
                    <a:gd name="connsiteY1" fmla="*/ 52252 h 1084218"/>
                    <a:gd name="connsiteX2" fmla="*/ 104503 w 1645920"/>
                    <a:gd name="connsiteY2" fmla="*/ 78378 h 1084218"/>
                    <a:gd name="connsiteX3" fmla="*/ 182880 w 1645920"/>
                    <a:gd name="connsiteY3" fmla="*/ 143692 h 1084218"/>
                    <a:gd name="connsiteX4" fmla="*/ 209006 w 1645920"/>
                    <a:gd name="connsiteY4" fmla="*/ 182880 h 1084218"/>
                    <a:gd name="connsiteX5" fmla="*/ 287383 w 1645920"/>
                    <a:gd name="connsiteY5" fmla="*/ 235132 h 1084218"/>
                    <a:gd name="connsiteX6" fmla="*/ 352697 w 1645920"/>
                    <a:gd name="connsiteY6" fmla="*/ 313509 h 1084218"/>
                    <a:gd name="connsiteX7" fmla="*/ 404949 w 1645920"/>
                    <a:gd name="connsiteY7" fmla="*/ 391886 h 1084218"/>
                    <a:gd name="connsiteX8" fmla="*/ 431074 w 1645920"/>
                    <a:gd name="connsiteY8" fmla="*/ 431075 h 1084218"/>
                    <a:gd name="connsiteX9" fmla="*/ 470263 w 1645920"/>
                    <a:gd name="connsiteY9" fmla="*/ 457200 h 1084218"/>
                    <a:gd name="connsiteX10" fmla="*/ 561703 w 1645920"/>
                    <a:gd name="connsiteY10" fmla="*/ 561703 h 1084218"/>
                    <a:gd name="connsiteX11" fmla="*/ 627017 w 1645920"/>
                    <a:gd name="connsiteY11" fmla="*/ 627018 h 1084218"/>
                    <a:gd name="connsiteX12" fmla="*/ 653143 w 1645920"/>
                    <a:gd name="connsiteY12" fmla="*/ 666206 h 1084218"/>
                    <a:gd name="connsiteX13" fmla="*/ 731520 w 1645920"/>
                    <a:gd name="connsiteY13" fmla="*/ 718458 h 1084218"/>
                    <a:gd name="connsiteX14" fmla="*/ 757646 w 1645920"/>
                    <a:gd name="connsiteY14" fmla="*/ 757646 h 1084218"/>
                    <a:gd name="connsiteX15" fmla="*/ 901337 w 1645920"/>
                    <a:gd name="connsiteY15" fmla="*/ 836023 h 1084218"/>
                    <a:gd name="connsiteX16" fmla="*/ 953589 w 1645920"/>
                    <a:gd name="connsiteY16" fmla="*/ 862149 h 1084218"/>
                    <a:gd name="connsiteX17" fmla="*/ 992777 w 1645920"/>
                    <a:gd name="connsiteY17" fmla="*/ 888275 h 1084218"/>
                    <a:gd name="connsiteX18" fmla="*/ 1123406 w 1645920"/>
                    <a:gd name="connsiteY18" fmla="*/ 914400 h 1084218"/>
                    <a:gd name="connsiteX19" fmla="*/ 1397726 w 1645920"/>
                    <a:gd name="connsiteY19" fmla="*/ 940526 h 1084218"/>
                    <a:gd name="connsiteX20" fmla="*/ 1476103 w 1645920"/>
                    <a:gd name="connsiteY20" fmla="*/ 966652 h 1084218"/>
                    <a:gd name="connsiteX21" fmla="*/ 1515292 w 1645920"/>
                    <a:gd name="connsiteY21" fmla="*/ 979715 h 1084218"/>
                    <a:gd name="connsiteX22" fmla="*/ 1593669 w 1645920"/>
                    <a:gd name="connsiteY22" fmla="*/ 1031966 h 1084218"/>
                    <a:gd name="connsiteX23" fmla="*/ 1645920 w 1645920"/>
                    <a:gd name="connsiteY23" fmla="*/ 1084218 h 1084218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</a:cxnLst>
                  <a:rect l="l" t="t" r="r" b="b"/>
                  <a:pathLst>
                    <a:path w="1645920" h="1084218">
                      <a:moveTo>
                        <a:pt x="0" y="0"/>
                      </a:moveTo>
                      <a:cubicBezTo>
                        <a:pt x="21771" y="17417"/>
                        <a:pt x="43009" y="35523"/>
                        <a:pt x="65314" y="52252"/>
                      </a:cubicBezTo>
                      <a:cubicBezTo>
                        <a:pt x="77874" y="61672"/>
                        <a:pt x="92442" y="68327"/>
                        <a:pt x="104503" y="78378"/>
                      </a:cubicBezTo>
                      <a:cubicBezTo>
                        <a:pt x="205089" y="162198"/>
                        <a:pt x="85578" y="78823"/>
                        <a:pt x="182880" y="143692"/>
                      </a:cubicBezTo>
                      <a:cubicBezTo>
                        <a:pt x="191589" y="156755"/>
                        <a:pt x="197191" y="172542"/>
                        <a:pt x="209006" y="182880"/>
                      </a:cubicBezTo>
                      <a:cubicBezTo>
                        <a:pt x="232636" y="203557"/>
                        <a:pt x="287383" y="235132"/>
                        <a:pt x="287383" y="235132"/>
                      </a:cubicBezTo>
                      <a:cubicBezTo>
                        <a:pt x="380746" y="375173"/>
                        <a:pt x="235348" y="162631"/>
                        <a:pt x="352697" y="313509"/>
                      </a:cubicBezTo>
                      <a:cubicBezTo>
                        <a:pt x="371974" y="338294"/>
                        <a:pt x="387532" y="365760"/>
                        <a:pt x="404949" y="391886"/>
                      </a:cubicBezTo>
                      <a:cubicBezTo>
                        <a:pt x="413658" y="404949"/>
                        <a:pt x="418011" y="422367"/>
                        <a:pt x="431074" y="431075"/>
                      </a:cubicBezTo>
                      <a:lnTo>
                        <a:pt x="470263" y="457200"/>
                      </a:lnTo>
                      <a:cubicBezTo>
                        <a:pt x="531222" y="548641"/>
                        <a:pt x="496388" y="518161"/>
                        <a:pt x="561703" y="561703"/>
                      </a:cubicBezTo>
                      <a:cubicBezTo>
                        <a:pt x="631370" y="666204"/>
                        <a:pt x="539934" y="539935"/>
                        <a:pt x="627017" y="627018"/>
                      </a:cubicBezTo>
                      <a:cubicBezTo>
                        <a:pt x="638118" y="638119"/>
                        <a:pt x="641328" y="655868"/>
                        <a:pt x="653143" y="666206"/>
                      </a:cubicBezTo>
                      <a:cubicBezTo>
                        <a:pt x="676773" y="686883"/>
                        <a:pt x="731520" y="718458"/>
                        <a:pt x="731520" y="718458"/>
                      </a:cubicBezTo>
                      <a:cubicBezTo>
                        <a:pt x="740229" y="731521"/>
                        <a:pt x="746545" y="746545"/>
                        <a:pt x="757646" y="757646"/>
                      </a:cubicBezTo>
                      <a:cubicBezTo>
                        <a:pt x="781513" y="781513"/>
                        <a:pt x="901185" y="835947"/>
                        <a:pt x="901337" y="836023"/>
                      </a:cubicBezTo>
                      <a:cubicBezTo>
                        <a:pt x="918754" y="844732"/>
                        <a:pt x="937386" y="851347"/>
                        <a:pt x="953589" y="862149"/>
                      </a:cubicBezTo>
                      <a:cubicBezTo>
                        <a:pt x="966652" y="870858"/>
                        <a:pt x="977772" y="883658"/>
                        <a:pt x="992777" y="888275"/>
                      </a:cubicBezTo>
                      <a:cubicBezTo>
                        <a:pt x="1035219" y="901334"/>
                        <a:pt x="1079863" y="905692"/>
                        <a:pt x="1123406" y="914400"/>
                      </a:cubicBezTo>
                      <a:cubicBezTo>
                        <a:pt x="1257175" y="941153"/>
                        <a:pt x="1166542" y="926077"/>
                        <a:pt x="1397726" y="940526"/>
                      </a:cubicBezTo>
                      <a:lnTo>
                        <a:pt x="1476103" y="966652"/>
                      </a:lnTo>
                      <a:cubicBezTo>
                        <a:pt x="1489166" y="971006"/>
                        <a:pt x="1503835" y="972077"/>
                        <a:pt x="1515292" y="979715"/>
                      </a:cubicBezTo>
                      <a:lnTo>
                        <a:pt x="1593669" y="1031966"/>
                      </a:lnTo>
                      <a:cubicBezTo>
                        <a:pt x="1640958" y="1063492"/>
                        <a:pt x="1625836" y="1044051"/>
                        <a:pt x="1645920" y="1084218"/>
                      </a:cubicBezTo>
                    </a:path>
                  </a:pathLst>
                </a:custGeom>
                <a:noFill/>
                <a:ln w="285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sp>
            <p:nvSpPr>
              <p:cNvPr id="53" name="Freeform 52">
                <a:extLst>
                  <a:ext uri="{FF2B5EF4-FFF2-40B4-BE49-F238E27FC236}">
                    <a16:creationId xmlns:a16="http://schemas.microsoft.com/office/drawing/2014/main" id="{B051A192-2194-B047-934E-CB8685FBC168}"/>
                  </a:ext>
                </a:extLst>
              </p:cNvPr>
              <p:cNvSpPr/>
              <p:nvPr/>
            </p:nvSpPr>
            <p:spPr>
              <a:xfrm rot="8200495">
                <a:off x="3431644" y="3204763"/>
                <a:ext cx="861517" cy="504350"/>
              </a:xfrm>
              <a:custGeom>
                <a:avLst/>
                <a:gdLst>
                  <a:gd name="connsiteX0" fmla="*/ 0 w 1645920"/>
                  <a:gd name="connsiteY0" fmla="*/ 0 h 1084218"/>
                  <a:gd name="connsiteX1" fmla="*/ 65314 w 1645920"/>
                  <a:gd name="connsiteY1" fmla="*/ 52252 h 1084218"/>
                  <a:gd name="connsiteX2" fmla="*/ 104503 w 1645920"/>
                  <a:gd name="connsiteY2" fmla="*/ 78378 h 1084218"/>
                  <a:gd name="connsiteX3" fmla="*/ 182880 w 1645920"/>
                  <a:gd name="connsiteY3" fmla="*/ 143692 h 1084218"/>
                  <a:gd name="connsiteX4" fmla="*/ 209006 w 1645920"/>
                  <a:gd name="connsiteY4" fmla="*/ 182880 h 1084218"/>
                  <a:gd name="connsiteX5" fmla="*/ 287383 w 1645920"/>
                  <a:gd name="connsiteY5" fmla="*/ 235132 h 1084218"/>
                  <a:gd name="connsiteX6" fmla="*/ 352697 w 1645920"/>
                  <a:gd name="connsiteY6" fmla="*/ 313509 h 1084218"/>
                  <a:gd name="connsiteX7" fmla="*/ 404949 w 1645920"/>
                  <a:gd name="connsiteY7" fmla="*/ 391886 h 1084218"/>
                  <a:gd name="connsiteX8" fmla="*/ 431074 w 1645920"/>
                  <a:gd name="connsiteY8" fmla="*/ 431075 h 1084218"/>
                  <a:gd name="connsiteX9" fmla="*/ 470263 w 1645920"/>
                  <a:gd name="connsiteY9" fmla="*/ 457200 h 1084218"/>
                  <a:gd name="connsiteX10" fmla="*/ 561703 w 1645920"/>
                  <a:gd name="connsiteY10" fmla="*/ 561703 h 1084218"/>
                  <a:gd name="connsiteX11" fmla="*/ 627017 w 1645920"/>
                  <a:gd name="connsiteY11" fmla="*/ 627018 h 1084218"/>
                  <a:gd name="connsiteX12" fmla="*/ 653143 w 1645920"/>
                  <a:gd name="connsiteY12" fmla="*/ 666206 h 1084218"/>
                  <a:gd name="connsiteX13" fmla="*/ 731520 w 1645920"/>
                  <a:gd name="connsiteY13" fmla="*/ 718458 h 1084218"/>
                  <a:gd name="connsiteX14" fmla="*/ 757646 w 1645920"/>
                  <a:gd name="connsiteY14" fmla="*/ 757646 h 1084218"/>
                  <a:gd name="connsiteX15" fmla="*/ 901337 w 1645920"/>
                  <a:gd name="connsiteY15" fmla="*/ 836023 h 1084218"/>
                  <a:gd name="connsiteX16" fmla="*/ 953589 w 1645920"/>
                  <a:gd name="connsiteY16" fmla="*/ 862149 h 1084218"/>
                  <a:gd name="connsiteX17" fmla="*/ 992777 w 1645920"/>
                  <a:gd name="connsiteY17" fmla="*/ 888275 h 1084218"/>
                  <a:gd name="connsiteX18" fmla="*/ 1123406 w 1645920"/>
                  <a:gd name="connsiteY18" fmla="*/ 914400 h 1084218"/>
                  <a:gd name="connsiteX19" fmla="*/ 1397726 w 1645920"/>
                  <a:gd name="connsiteY19" fmla="*/ 940526 h 1084218"/>
                  <a:gd name="connsiteX20" fmla="*/ 1476103 w 1645920"/>
                  <a:gd name="connsiteY20" fmla="*/ 966652 h 1084218"/>
                  <a:gd name="connsiteX21" fmla="*/ 1515292 w 1645920"/>
                  <a:gd name="connsiteY21" fmla="*/ 979715 h 1084218"/>
                  <a:gd name="connsiteX22" fmla="*/ 1593669 w 1645920"/>
                  <a:gd name="connsiteY22" fmla="*/ 1031966 h 1084218"/>
                  <a:gd name="connsiteX23" fmla="*/ 1645920 w 1645920"/>
                  <a:gd name="connsiteY23" fmla="*/ 1084218 h 108421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</a:cxnLst>
                <a:rect l="l" t="t" r="r" b="b"/>
                <a:pathLst>
                  <a:path w="1645920" h="1084218">
                    <a:moveTo>
                      <a:pt x="0" y="0"/>
                    </a:moveTo>
                    <a:cubicBezTo>
                      <a:pt x="21771" y="17417"/>
                      <a:pt x="43009" y="35523"/>
                      <a:pt x="65314" y="52252"/>
                    </a:cubicBezTo>
                    <a:cubicBezTo>
                      <a:pt x="77874" y="61672"/>
                      <a:pt x="92442" y="68327"/>
                      <a:pt x="104503" y="78378"/>
                    </a:cubicBezTo>
                    <a:cubicBezTo>
                      <a:pt x="205089" y="162198"/>
                      <a:pt x="85578" y="78823"/>
                      <a:pt x="182880" y="143692"/>
                    </a:cubicBezTo>
                    <a:cubicBezTo>
                      <a:pt x="191589" y="156755"/>
                      <a:pt x="197191" y="172542"/>
                      <a:pt x="209006" y="182880"/>
                    </a:cubicBezTo>
                    <a:cubicBezTo>
                      <a:pt x="232636" y="203557"/>
                      <a:pt x="287383" y="235132"/>
                      <a:pt x="287383" y="235132"/>
                    </a:cubicBezTo>
                    <a:cubicBezTo>
                      <a:pt x="380746" y="375173"/>
                      <a:pt x="235348" y="162631"/>
                      <a:pt x="352697" y="313509"/>
                    </a:cubicBezTo>
                    <a:cubicBezTo>
                      <a:pt x="371974" y="338294"/>
                      <a:pt x="387532" y="365760"/>
                      <a:pt x="404949" y="391886"/>
                    </a:cubicBezTo>
                    <a:cubicBezTo>
                      <a:pt x="413658" y="404949"/>
                      <a:pt x="418011" y="422367"/>
                      <a:pt x="431074" y="431075"/>
                    </a:cubicBezTo>
                    <a:lnTo>
                      <a:pt x="470263" y="457200"/>
                    </a:lnTo>
                    <a:cubicBezTo>
                      <a:pt x="531222" y="548641"/>
                      <a:pt x="496388" y="518161"/>
                      <a:pt x="561703" y="561703"/>
                    </a:cubicBezTo>
                    <a:cubicBezTo>
                      <a:pt x="631370" y="666204"/>
                      <a:pt x="539934" y="539935"/>
                      <a:pt x="627017" y="627018"/>
                    </a:cubicBezTo>
                    <a:cubicBezTo>
                      <a:pt x="638118" y="638119"/>
                      <a:pt x="641328" y="655868"/>
                      <a:pt x="653143" y="666206"/>
                    </a:cubicBezTo>
                    <a:cubicBezTo>
                      <a:pt x="676773" y="686883"/>
                      <a:pt x="731520" y="718458"/>
                      <a:pt x="731520" y="718458"/>
                    </a:cubicBezTo>
                    <a:cubicBezTo>
                      <a:pt x="740229" y="731521"/>
                      <a:pt x="746545" y="746545"/>
                      <a:pt x="757646" y="757646"/>
                    </a:cubicBezTo>
                    <a:cubicBezTo>
                      <a:pt x="781513" y="781513"/>
                      <a:pt x="901185" y="835947"/>
                      <a:pt x="901337" y="836023"/>
                    </a:cubicBezTo>
                    <a:cubicBezTo>
                      <a:pt x="918754" y="844732"/>
                      <a:pt x="937386" y="851347"/>
                      <a:pt x="953589" y="862149"/>
                    </a:cubicBezTo>
                    <a:cubicBezTo>
                      <a:pt x="966652" y="870858"/>
                      <a:pt x="977772" y="883658"/>
                      <a:pt x="992777" y="888275"/>
                    </a:cubicBezTo>
                    <a:cubicBezTo>
                      <a:pt x="1035219" y="901334"/>
                      <a:pt x="1079863" y="905692"/>
                      <a:pt x="1123406" y="914400"/>
                    </a:cubicBezTo>
                    <a:cubicBezTo>
                      <a:pt x="1257175" y="941153"/>
                      <a:pt x="1166542" y="926077"/>
                      <a:pt x="1397726" y="940526"/>
                    </a:cubicBezTo>
                    <a:lnTo>
                      <a:pt x="1476103" y="966652"/>
                    </a:lnTo>
                    <a:cubicBezTo>
                      <a:pt x="1489166" y="971006"/>
                      <a:pt x="1503835" y="972077"/>
                      <a:pt x="1515292" y="979715"/>
                    </a:cubicBezTo>
                    <a:lnTo>
                      <a:pt x="1593669" y="1031966"/>
                    </a:lnTo>
                    <a:cubicBezTo>
                      <a:pt x="1640958" y="1063492"/>
                      <a:pt x="1625836" y="1044051"/>
                      <a:pt x="1645920" y="1084218"/>
                    </a:cubicBezTo>
                  </a:path>
                </a:pathLst>
              </a:cu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97C856F3-BC42-514E-920B-0CAE1AEE2B2A}"/>
                </a:ext>
              </a:extLst>
            </p:cNvPr>
            <p:cNvGrpSpPr/>
            <p:nvPr/>
          </p:nvGrpSpPr>
          <p:grpSpPr>
            <a:xfrm>
              <a:off x="7437824" y="1725791"/>
              <a:ext cx="1954216" cy="1313999"/>
              <a:chOff x="3087525" y="3143683"/>
              <a:chExt cx="2138506" cy="1633426"/>
            </a:xfrm>
          </p:grpSpPr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F396E7F0-FE03-B547-A50E-ABB0A839B717}"/>
                  </a:ext>
                </a:extLst>
              </p:cNvPr>
              <p:cNvSpPr txBox="1"/>
              <p:nvPr/>
            </p:nvSpPr>
            <p:spPr>
              <a:xfrm>
                <a:off x="3087525" y="3392328"/>
                <a:ext cx="68015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B</a:t>
                </a: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08E75E7D-C758-8F4D-8552-4F04C2FE7696}"/>
                  </a:ext>
                </a:extLst>
              </p:cNvPr>
              <p:cNvSpPr txBox="1"/>
              <p:nvPr/>
            </p:nvSpPr>
            <p:spPr>
              <a:xfrm>
                <a:off x="3780282" y="3875102"/>
                <a:ext cx="680154" cy="3077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B</a:t>
                </a: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8B50E785-3FE5-FA41-81DC-182BC6B5AF9E}"/>
                  </a:ext>
                </a:extLst>
              </p:cNvPr>
              <p:cNvSpPr txBox="1"/>
              <p:nvPr/>
            </p:nvSpPr>
            <p:spPr>
              <a:xfrm>
                <a:off x="3714070" y="3143683"/>
                <a:ext cx="68015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B</a:t>
                </a: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9719BE8C-D87A-8046-85DF-652277C91B15}"/>
                  </a:ext>
                </a:extLst>
              </p:cNvPr>
              <p:cNvSpPr txBox="1"/>
              <p:nvPr/>
            </p:nvSpPr>
            <p:spPr>
              <a:xfrm>
                <a:off x="4530689" y="3585648"/>
                <a:ext cx="68015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F</a:t>
                </a: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D1DB5FE2-9F7B-ED4F-B6F5-0A25EDC68D75}"/>
                  </a:ext>
                </a:extLst>
              </p:cNvPr>
              <p:cNvSpPr txBox="1"/>
              <p:nvPr/>
            </p:nvSpPr>
            <p:spPr>
              <a:xfrm>
                <a:off x="4545877" y="4469332"/>
                <a:ext cx="68015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4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PF</a:t>
                </a:r>
              </a:p>
            </p:txBody>
          </p:sp>
        </p:grpSp>
      </p:grpSp>
      <p:pic>
        <p:nvPicPr>
          <p:cNvPr id="59" name="Picture 58">
            <a:extLst>
              <a:ext uri="{FF2B5EF4-FFF2-40B4-BE49-F238E27FC236}">
                <a16:creationId xmlns:a16="http://schemas.microsoft.com/office/drawing/2014/main" id="{CDD376AF-5BBB-C74E-803C-02F5381974F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18287" y="3544582"/>
            <a:ext cx="3995483" cy="3313417"/>
          </a:xfrm>
          <a:prstGeom prst="rect">
            <a:avLst/>
          </a:prstGeom>
        </p:spPr>
      </p:pic>
      <p:sp>
        <p:nvSpPr>
          <p:cNvPr id="60" name="TextBox 59">
            <a:extLst>
              <a:ext uri="{FF2B5EF4-FFF2-40B4-BE49-F238E27FC236}">
                <a16:creationId xmlns:a16="http://schemas.microsoft.com/office/drawing/2014/main" id="{977B8C99-140B-8247-8C69-1D9DB005FC6F}"/>
              </a:ext>
            </a:extLst>
          </p:cNvPr>
          <p:cNvSpPr txBox="1"/>
          <p:nvPr/>
        </p:nvSpPr>
        <p:spPr>
          <a:xfrm>
            <a:off x="6218287" y="3554445"/>
            <a:ext cx="53466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61" name="Oval 60">
            <a:extLst>
              <a:ext uri="{FF2B5EF4-FFF2-40B4-BE49-F238E27FC236}">
                <a16:creationId xmlns:a16="http://schemas.microsoft.com/office/drawing/2014/main" id="{13A8AA89-C330-C045-A050-A170C18F74C8}"/>
              </a:ext>
            </a:extLst>
          </p:cNvPr>
          <p:cNvSpPr/>
          <p:nvPr/>
        </p:nvSpPr>
        <p:spPr>
          <a:xfrm rot="18248397">
            <a:off x="3351886" y="2082849"/>
            <a:ext cx="365760" cy="215756"/>
          </a:xfrm>
          <a:prstGeom prst="ellipse">
            <a:avLst/>
          </a:prstGeom>
          <a:solidFill>
            <a:schemeClr val="tx1">
              <a:alpha val="42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2" name="Oval 61">
            <a:extLst>
              <a:ext uri="{FF2B5EF4-FFF2-40B4-BE49-F238E27FC236}">
                <a16:creationId xmlns:a16="http://schemas.microsoft.com/office/drawing/2014/main" id="{2C87ED24-DE4F-794F-ADB8-B9029CCE57FA}"/>
              </a:ext>
            </a:extLst>
          </p:cNvPr>
          <p:cNvSpPr/>
          <p:nvPr/>
        </p:nvSpPr>
        <p:spPr>
          <a:xfrm rot="18248397">
            <a:off x="3470497" y="5683847"/>
            <a:ext cx="365760" cy="215756"/>
          </a:xfrm>
          <a:prstGeom prst="ellipse">
            <a:avLst/>
          </a:prstGeom>
          <a:solidFill>
            <a:schemeClr val="tx1">
              <a:alpha val="43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Oval 62">
            <a:extLst>
              <a:ext uri="{FF2B5EF4-FFF2-40B4-BE49-F238E27FC236}">
                <a16:creationId xmlns:a16="http://schemas.microsoft.com/office/drawing/2014/main" id="{E6791FC5-96BB-844F-9CC5-370020566B7F}"/>
              </a:ext>
            </a:extLst>
          </p:cNvPr>
          <p:cNvSpPr/>
          <p:nvPr/>
        </p:nvSpPr>
        <p:spPr>
          <a:xfrm rot="18248397">
            <a:off x="7345041" y="2341200"/>
            <a:ext cx="365760" cy="215756"/>
          </a:xfrm>
          <a:prstGeom prst="ellipse">
            <a:avLst/>
          </a:prstGeom>
          <a:solidFill>
            <a:schemeClr val="tx1">
              <a:alpha val="42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BB03858E-4334-4949-A789-D2A0F10AFCCA}"/>
              </a:ext>
            </a:extLst>
          </p:cNvPr>
          <p:cNvSpPr txBox="1"/>
          <p:nvPr/>
        </p:nvSpPr>
        <p:spPr>
          <a:xfrm>
            <a:off x="1752731" y="3039790"/>
            <a:ext cx="1326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O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B965D66-9AE0-0847-8D21-54B5C5862927}"/>
              </a:ext>
            </a:extLst>
          </p:cNvPr>
          <p:cNvSpPr txBox="1"/>
          <p:nvPr/>
        </p:nvSpPr>
        <p:spPr>
          <a:xfrm>
            <a:off x="5856548" y="3013523"/>
            <a:ext cx="1326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O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B917D463-EA7D-524E-98AE-485F3D1EAB2E}"/>
              </a:ext>
            </a:extLst>
          </p:cNvPr>
          <p:cNvSpPr txBox="1"/>
          <p:nvPr/>
        </p:nvSpPr>
        <p:spPr>
          <a:xfrm>
            <a:off x="1752731" y="6422015"/>
            <a:ext cx="1326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O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56F7E6A0-B62A-D14A-ABD7-FB127143445D}"/>
              </a:ext>
            </a:extLst>
          </p:cNvPr>
          <p:cNvSpPr txBox="1"/>
          <p:nvPr/>
        </p:nvSpPr>
        <p:spPr>
          <a:xfrm>
            <a:off x="6009452" y="6422015"/>
            <a:ext cx="1326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AO</a:t>
            </a:r>
          </a:p>
        </p:txBody>
      </p:sp>
      <p:sp>
        <p:nvSpPr>
          <p:cNvPr id="17" name="Right Bracket 16">
            <a:extLst>
              <a:ext uri="{FF2B5EF4-FFF2-40B4-BE49-F238E27FC236}">
                <a16:creationId xmlns:a16="http://schemas.microsoft.com/office/drawing/2014/main" id="{BF2E5B16-4277-6441-9539-217AA643F2DD}"/>
              </a:ext>
            </a:extLst>
          </p:cNvPr>
          <p:cNvSpPr/>
          <p:nvPr/>
        </p:nvSpPr>
        <p:spPr>
          <a:xfrm rot="3555776">
            <a:off x="3833555" y="1970226"/>
            <a:ext cx="87840" cy="360023"/>
          </a:xfrm>
          <a:prstGeom prst="rightBracket">
            <a:avLst/>
          </a:prstGeom>
          <a:ln w="3810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59BE7D68-9884-A249-AC0B-40A0CE50089C}"/>
              </a:ext>
            </a:extLst>
          </p:cNvPr>
          <p:cNvSpPr txBox="1"/>
          <p:nvPr/>
        </p:nvSpPr>
        <p:spPr>
          <a:xfrm>
            <a:off x="3152706" y="2392683"/>
            <a:ext cx="572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N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89DB3995-3C0E-9541-B0E3-DA2854BDB3F7}"/>
              </a:ext>
            </a:extLst>
          </p:cNvPr>
          <p:cNvSpPr txBox="1"/>
          <p:nvPr/>
        </p:nvSpPr>
        <p:spPr>
          <a:xfrm>
            <a:off x="6912234" y="2533704"/>
            <a:ext cx="572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N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6EC62999-4617-FB4D-9A62-A7EC7906AB07}"/>
              </a:ext>
            </a:extLst>
          </p:cNvPr>
          <p:cNvSpPr txBox="1"/>
          <p:nvPr/>
        </p:nvSpPr>
        <p:spPr>
          <a:xfrm>
            <a:off x="3181509" y="5976403"/>
            <a:ext cx="572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N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D5BB55F0-1D7A-F741-9AF7-0ED2376FC65B}"/>
              </a:ext>
            </a:extLst>
          </p:cNvPr>
          <p:cNvSpPr txBox="1"/>
          <p:nvPr/>
        </p:nvSpPr>
        <p:spPr>
          <a:xfrm>
            <a:off x="3811369" y="1771050"/>
            <a:ext cx="33855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32546699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FA35B83-C882-CE41-8DC0-6ADA586A550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saturation sat="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767906" y="1396258"/>
            <a:ext cx="8656188" cy="530498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31E1961-E225-BC4A-A5FD-42D78C0D431C}"/>
              </a:ext>
            </a:extLst>
          </p:cNvPr>
          <p:cNvSpPr txBox="1"/>
          <p:nvPr/>
        </p:nvSpPr>
        <p:spPr>
          <a:xfrm>
            <a:off x="1767905" y="1396258"/>
            <a:ext cx="431938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2AD86E7-C3DF-7E4D-8FBC-C283DC3609C2}"/>
              </a:ext>
            </a:extLst>
          </p:cNvPr>
          <p:cNvSpPr txBox="1"/>
          <p:nvPr/>
        </p:nvSpPr>
        <p:spPr>
          <a:xfrm>
            <a:off x="5251333" y="5976966"/>
            <a:ext cx="431938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AI @70 bpm</a:t>
            </a:r>
          </a:p>
        </p:txBody>
      </p:sp>
    </p:spTree>
    <p:extLst>
      <p:ext uri="{BB962C8B-B14F-4D97-AF65-F5344CB8AC3E}">
        <p14:creationId xmlns:p14="http://schemas.microsoft.com/office/powerpoint/2010/main" val="9745754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7</Words>
  <Application>Microsoft Office PowerPoint</Application>
  <PresentationFormat>Widescreen</PresentationFormat>
  <Paragraphs>3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Deivanai S Sambathkumar</cp:lastModifiedBy>
  <cp:revision>3</cp:revision>
  <dcterms:created xsi:type="dcterms:W3CDTF">2023-11-02T03:54:56Z</dcterms:created>
  <dcterms:modified xsi:type="dcterms:W3CDTF">2023-12-12T10:15:24Z</dcterms:modified>
</cp:coreProperties>
</file>